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>
        <p15:guide id="7" orient="horz" pos="99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2767"/>
    </p:ext>
    <p:ext uri="{FD5EFAAD-0ECE-453E-9831-46B23BE46B34}">
      <p15:chartTrackingRefBased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8663"/>
    <p:restoredTop sz="94674"/>
  </p:normalViewPr>
  <p:slideViewPr>
    <p:cSldViewPr snapToGrid="0" snapToObjects="1" showGuides="1">
      <p:cViewPr>
        <p:scale>
          <a:sx n="50" d="100"/>
          <a:sy n="50" d="100"/>
        </p:scale>
        <p:origin x="-2152" y="-376"/>
      </p:cViewPr>
      <p:guideLst>
        <p:guide orient="horz" pos="99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820970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946437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13384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29480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775044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524415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199161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67086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502618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7899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144450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56919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jpeg"/><Relationship Id="rId11" Type="http://schemas.openxmlformats.org/officeDocument/2006/relationships/image" Target="../media/image10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3" name="Grouper 332"/>
          <p:cNvGrpSpPr/>
          <p:nvPr/>
        </p:nvGrpSpPr>
        <p:grpSpPr>
          <a:xfrm>
            <a:off x="-50482" y="-2377"/>
            <a:ext cx="6908482" cy="9074218"/>
            <a:chOff x="-50482" y="-2377"/>
            <a:chExt cx="6908482" cy="9074218"/>
          </a:xfrm>
        </p:grpSpPr>
        <p:grpSp>
          <p:nvGrpSpPr>
            <p:cNvPr id="24" name="Groupe 23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E8FB8E8-BB84-394E-9311-1E0AD2AF02EE}"/>
                </a:ext>
              </a:extLst>
            </p:cNvPr>
            <p:cNvGrpSpPr/>
            <p:nvPr/>
          </p:nvGrpSpPr>
          <p:grpSpPr>
            <a:xfrm>
              <a:off x="-29902" y="-2377"/>
              <a:ext cx="6354507" cy="1595151"/>
              <a:chOff x="-29902" y="-2377"/>
              <a:chExt cx="6354507" cy="1595151"/>
            </a:xfrm>
          </p:grpSpPr>
          <p:grpSp>
            <p:nvGrpSpPr>
              <p:cNvPr id="499" name="Groupe 498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E5CA96-E29C-E147-8505-44BFED75E3E9}"/>
                  </a:ext>
                </a:extLst>
              </p:cNvPr>
              <p:cNvGrpSpPr/>
              <p:nvPr/>
            </p:nvGrpSpPr>
            <p:grpSpPr>
              <a:xfrm>
                <a:off x="672651" y="0"/>
                <a:ext cx="5651954" cy="1592774"/>
                <a:chOff x="331530" y="855306"/>
                <a:chExt cx="5651954" cy="1592774"/>
              </a:xfrm>
            </p:grpSpPr>
            <p:grpSp>
              <p:nvGrpSpPr>
                <p:cNvPr id="143" name="Group 5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E074286-293C-E142-B1FD-7A597B3418AD}"/>
                    </a:ext>
                  </a:extLst>
                </p:cNvPr>
                <p:cNvGrpSpPr/>
                <p:nvPr/>
              </p:nvGrpSpPr>
              <p:grpSpPr>
                <a:xfrm>
                  <a:off x="331530" y="855306"/>
                  <a:ext cx="5651954" cy="1161143"/>
                  <a:chOff x="3360559" y="2162578"/>
                  <a:chExt cx="3136270" cy="1045421"/>
                </a:xfrm>
              </p:grpSpPr>
              <p:cxnSp>
                <p:nvCxnSpPr>
                  <p:cNvPr id="146" name="Straight Connector 2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1654613-5600-404D-BD00-57D47729B0A7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3360559" y="3078090"/>
                    <a:ext cx="3136270" cy="542"/>
                  </a:xfrm>
                  <a:prstGeom prst="line">
                    <a:avLst/>
                  </a:prstGeom>
                  <a:ln w="19050" cap="flat" cmpd="sng" algn="ctr">
                    <a:solidFill>
                      <a:schemeClr val="dk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4" name="Down Arrow 3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C8C28F3-C30D-754C-814A-2EA2C0AE5D5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6200000">
                    <a:off x="4838075" y="2963183"/>
                    <a:ext cx="259274" cy="230355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5" name="Down Arrow 3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2CE9774-6251-804E-BA2F-5D09148E57A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6200000">
                    <a:off x="4616940" y="2964929"/>
                    <a:ext cx="259274" cy="226864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6" name="Down Arrow 3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B6B1A5A-9827-5F4D-B7C0-58E37B3E30A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6200000">
                    <a:off x="4370516" y="2934259"/>
                    <a:ext cx="259274" cy="288204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 b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7" name="Down Arrow 3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D8EF5F5-0E75-2E40-A710-FA84731520E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6200000">
                    <a:off x="4059359" y="2904838"/>
                    <a:ext cx="259274" cy="347047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 b="1" i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8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3EFF318-ABBA-A948-A598-9EAC1BFF724E}"/>
                      </a:ext>
                    </a:extLst>
                  </p:cNvPr>
                  <p:cNvSpPr txBox="1"/>
                  <p:nvPr/>
                </p:nvSpPr>
                <p:spPr>
                  <a:xfrm>
                    <a:off x="3950075" y="2505775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40</a:t>
                    </a:r>
                  </a:p>
                </p:txBody>
              </p:sp>
              <p:sp>
                <p:nvSpPr>
                  <p:cNvPr id="159" name="TextBox 3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3079DCC-99F9-E844-A218-2C24593A254A}"/>
                      </a:ext>
                    </a:extLst>
                  </p:cNvPr>
                  <p:cNvSpPr txBox="1"/>
                  <p:nvPr/>
                </p:nvSpPr>
                <p:spPr>
                  <a:xfrm>
                    <a:off x="3956457" y="2730799"/>
                    <a:ext cx="346227" cy="235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emA</a:t>
                    </a:r>
                    <a:endParaRPr lang="en-US" sz="11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0" name="TextBox 3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D8E2D6D-53C8-1745-AE38-43028480BFA1}"/>
                      </a:ext>
                    </a:extLst>
                  </p:cNvPr>
                  <p:cNvSpPr txBox="1"/>
                  <p:nvPr/>
                </p:nvSpPr>
                <p:spPr>
                  <a:xfrm>
                    <a:off x="4247969" y="2730799"/>
                    <a:ext cx="418987" cy="235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emC</a:t>
                    </a:r>
                    <a:r>
                      <a:rPr lang="en-US" sz="11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/D</a:t>
                    </a:r>
                  </a:p>
                </p:txBody>
              </p:sp>
              <p:sp>
                <p:nvSpPr>
                  <p:cNvPr id="161" name="Down Arrow 4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209C9BE-3370-1243-BC7C-7D0E796AA5C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6200000">
                    <a:off x="5512451" y="2951165"/>
                    <a:ext cx="259274" cy="254393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2" name="Down Arrow 4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BB50F8D-22C3-344B-A2EF-2A9A4C78ECD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6200000">
                    <a:off x="5280283" y="2963183"/>
                    <a:ext cx="259274" cy="230355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3" name="Down Arrow 4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DCB4110-A846-8648-A023-022381D87E9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6200000">
                    <a:off x="5058896" y="2963183"/>
                    <a:ext cx="259274" cy="230355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4" name="TextBox 5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788402D-01A7-344F-93DC-9D4DABE71A8B}"/>
                      </a:ext>
                    </a:extLst>
                  </p:cNvPr>
                  <p:cNvSpPr txBox="1"/>
                  <p:nvPr/>
                </p:nvSpPr>
                <p:spPr>
                  <a:xfrm>
                    <a:off x="4525626" y="2436384"/>
                    <a:ext cx="348486" cy="235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emB</a:t>
                    </a:r>
                    <a:endParaRPr lang="en-US" sz="11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5" name="TextBox 5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C436130-89D7-0C46-A8A1-91DA1956137D}"/>
                      </a:ext>
                    </a:extLst>
                  </p:cNvPr>
                  <p:cNvSpPr txBox="1"/>
                  <p:nvPr/>
                </p:nvSpPr>
                <p:spPr>
                  <a:xfrm>
                    <a:off x="4794905" y="2727524"/>
                    <a:ext cx="354653" cy="235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emL</a:t>
                    </a:r>
                    <a:endParaRPr lang="en-US" sz="11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6" name="TextBox 5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99C2D2C-BC27-6A44-902A-5487F32CE9B4}"/>
                      </a:ext>
                    </a:extLst>
                  </p:cNvPr>
                  <p:cNvSpPr txBox="1"/>
                  <p:nvPr/>
                </p:nvSpPr>
                <p:spPr>
                  <a:xfrm>
                    <a:off x="5031377" y="2463648"/>
                    <a:ext cx="235382" cy="235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K</a:t>
                    </a:r>
                  </a:p>
                </p:txBody>
              </p:sp>
              <p:sp>
                <p:nvSpPr>
                  <p:cNvPr id="167" name="TextBox 5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F729E91-200C-FC46-812E-785A600699AD}"/>
                      </a:ext>
                    </a:extLst>
                  </p:cNvPr>
                  <p:cNvSpPr txBox="1"/>
                  <p:nvPr/>
                </p:nvSpPr>
                <p:spPr>
                  <a:xfrm>
                    <a:off x="5274098" y="2730799"/>
                    <a:ext cx="223515" cy="235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R</a:t>
                    </a:r>
                  </a:p>
                </p:txBody>
              </p:sp>
              <p:sp>
                <p:nvSpPr>
                  <p:cNvPr id="168" name="TextBox 5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9895714-05E0-7141-ACFD-A4DF83B868AE}"/>
                      </a:ext>
                    </a:extLst>
                  </p:cNvPr>
                  <p:cNvSpPr txBox="1"/>
                  <p:nvPr/>
                </p:nvSpPr>
                <p:spPr>
                  <a:xfrm>
                    <a:off x="5437484" y="2488983"/>
                    <a:ext cx="391953" cy="235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emE</a:t>
                    </a:r>
                    <a:endParaRPr lang="en-US" sz="11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9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837FA77-47F7-9B43-8E80-94C185E9906F}"/>
                      </a:ext>
                    </a:extLst>
                  </p:cNvPr>
                  <p:cNvSpPr txBox="1"/>
                  <p:nvPr/>
                </p:nvSpPr>
                <p:spPr>
                  <a:xfrm>
                    <a:off x="4277973" y="2457876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45</a:t>
                    </a:r>
                  </a:p>
                </p:txBody>
              </p:sp>
              <p:sp>
                <p:nvSpPr>
                  <p:cNvPr id="170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3C07624-AD60-3C41-B0F5-06B86C161C85}"/>
                      </a:ext>
                    </a:extLst>
                  </p:cNvPr>
                  <p:cNvSpPr txBox="1"/>
                  <p:nvPr/>
                </p:nvSpPr>
                <p:spPr>
                  <a:xfrm>
                    <a:off x="4520376" y="2211528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50</a:t>
                    </a:r>
                  </a:p>
                </p:txBody>
              </p:sp>
              <p:sp>
                <p:nvSpPr>
                  <p:cNvPr id="171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04FE2DF-4CC2-514C-9471-02E5FF2AB078}"/>
                      </a:ext>
                    </a:extLst>
                  </p:cNvPr>
                  <p:cNvSpPr txBox="1"/>
                  <p:nvPr/>
                </p:nvSpPr>
                <p:spPr>
                  <a:xfrm>
                    <a:off x="4792738" y="2490744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55</a:t>
                    </a:r>
                  </a:p>
                </p:txBody>
              </p:sp>
              <p:sp>
                <p:nvSpPr>
                  <p:cNvPr id="172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D8AF2F2-08B6-7644-A675-336BC4D9E771}"/>
                      </a:ext>
                    </a:extLst>
                  </p:cNvPr>
                  <p:cNvSpPr txBox="1"/>
                  <p:nvPr/>
                </p:nvSpPr>
                <p:spPr>
                  <a:xfrm>
                    <a:off x="4969575" y="2162578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60</a:t>
                    </a:r>
                  </a:p>
                </p:txBody>
              </p:sp>
              <p:sp>
                <p:nvSpPr>
                  <p:cNvPr id="173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B388803-1444-A549-85D8-8A9D9F58D92D}"/>
                      </a:ext>
                    </a:extLst>
                  </p:cNvPr>
                  <p:cNvSpPr txBox="1"/>
                  <p:nvPr/>
                </p:nvSpPr>
                <p:spPr>
                  <a:xfrm>
                    <a:off x="5206362" y="2478745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65</a:t>
                    </a:r>
                  </a:p>
                </p:txBody>
              </p:sp>
              <p:sp>
                <p:nvSpPr>
                  <p:cNvPr id="174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7007589-CC95-9149-8042-3D6A8BF56040}"/>
                      </a:ext>
                    </a:extLst>
                  </p:cNvPr>
                  <p:cNvSpPr txBox="1"/>
                  <p:nvPr/>
                </p:nvSpPr>
                <p:spPr>
                  <a:xfrm>
                    <a:off x="5453967" y="2225435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70</a:t>
                    </a:r>
                  </a:p>
                </p:txBody>
              </p:sp>
              <p:sp>
                <p:nvSpPr>
                  <p:cNvPr id="175" name="Down Arrow 4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EC1375A-8E8D-0D43-ACBC-F91EFB76732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6200000">
                    <a:off x="5766845" y="2951165"/>
                    <a:ext cx="259274" cy="254393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6" name="TextBox 5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CDFA374-989C-B94B-B05C-214D0D3BDA1C}"/>
                      </a:ext>
                    </a:extLst>
                  </p:cNvPr>
                  <p:cNvSpPr txBox="1"/>
                  <p:nvPr/>
                </p:nvSpPr>
                <p:spPr>
                  <a:xfrm>
                    <a:off x="5700740" y="2730800"/>
                    <a:ext cx="391953" cy="235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emF</a:t>
                    </a:r>
                    <a:endParaRPr lang="en-US" sz="11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7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D97B25F-DFAD-C54E-9F4D-04AD6958B783}"/>
                      </a:ext>
                    </a:extLst>
                  </p:cNvPr>
                  <p:cNvSpPr txBox="1"/>
                  <p:nvPr/>
                </p:nvSpPr>
                <p:spPr>
                  <a:xfrm>
                    <a:off x="5717223" y="2456600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75</a:t>
                    </a:r>
                  </a:p>
                </p:txBody>
              </p:sp>
              <p:sp>
                <p:nvSpPr>
                  <p:cNvPr id="178" name="Down Arrow 4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2F7ED94-BE0B-5341-AF39-3ABD5009F3E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16200000">
                    <a:off x="6105662" y="2951165"/>
                    <a:ext cx="259274" cy="254393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9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EA20B3E-CE1C-7143-BF8C-5485700F6F75}"/>
                      </a:ext>
                    </a:extLst>
                  </p:cNvPr>
                  <p:cNvSpPr txBox="1"/>
                  <p:nvPr/>
                </p:nvSpPr>
                <p:spPr>
                  <a:xfrm>
                    <a:off x="6056610" y="2444789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80</a:t>
                    </a:r>
                  </a:p>
                </p:txBody>
              </p:sp>
              <p:sp>
                <p:nvSpPr>
                  <p:cNvPr id="180" name="TextBox 5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8BD5618-E52A-9D41-9D27-2D766D89B1FB}"/>
                      </a:ext>
                    </a:extLst>
                  </p:cNvPr>
                  <p:cNvSpPr txBox="1"/>
                  <p:nvPr/>
                </p:nvSpPr>
                <p:spPr>
                  <a:xfrm>
                    <a:off x="6045491" y="2724941"/>
                    <a:ext cx="381223" cy="2355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o</a:t>
                    </a:r>
                  </a:p>
                </p:txBody>
              </p:sp>
              <p:sp>
                <p:nvSpPr>
                  <p:cNvPr id="181" name="Down Arrow 4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8B4BBBA-D209-344A-9EA4-6B4C543C954A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 flipH="1">
                    <a:off x="3672908" y="3018433"/>
                    <a:ext cx="259274" cy="119855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2" name="Down Arrow 4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61DF7A4-E019-BD4D-BE84-2B91B1DAA811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16200000">
                    <a:off x="3498791" y="2948517"/>
                    <a:ext cx="259274" cy="259689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4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3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248CB16-5BC2-924A-9575-7FE3BECCB9C4}"/>
                      </a:ext>
                    </a:extLst>
                  </p:cNvPr>
                  <p:cNvSpPr txBox="1"/>
                  <p:nvPr/>
                </p:nvSpPr>
                <p:spPr>
                  <a:xfrm>
                    <a:off x="3647234" y="2417529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35</a:t>
                    </a:r>
                  </a:p>
                </p:txBody>
              </p:sp>
              <p:sp>
                <p:nvSpPr>
                  <p:cNvPr id="184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6B227B5-55EC-0045-919F-ABE1C7732EC8}"/>
                      </a:ext>
                    </a:extLst>
                  </p:cNvPr>
                  <p:cNvSpPr txBox="1"/>
                  <p:nvPr/>
                </p:nvSpPr>
                <p:spPr>
                  <a:xfrm>
                    <a:off x="3450576" y="2672815"/>
                    <a:ext cx="358986" cy="3325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_17830</a:t>
                    </a:r>
                  </a:p>
                </p:txBody>
              </p:sp>
            </p:grpSp>
            <p:sp>
              <p:nvSpPr>
                <p:cNvPr id="185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A9E23DE-D536-BD41-AAE6-AFE0369CE385}"/>
                    </a:ext>
                  </a:extLst>
                </p:cNvPr>
                <p:cNvSpPr txBox="1"/>
                <p:nvPr/>
              </p:nvSpPr>
              <p:spPr>
                <a:xfrm>
                  <a:off x="5061229" y="1921259"/>
                  <a:ext cx="25577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</a:p>
              </p:txBody>
            </p:sp>
            <p:sp>
              <p:nvSpPr>
                <p:cNvPr id="186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7AD00F4-B321-B640-A78C-BA751289C8DC}"/>
                    </a:ext>
                  </a:extLst>
                </p:cNvPr>
                <p:cNvSpPr txBox="1"/>
                <p:nvPr/>
              </p:nvSpPr>
              <p:spPr>
                <a:xfrm>
                  <a:off x="1233326" y="1921259"/>
                  <a:ext cx="25577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9</a:t>
                  </a:r>
                </a:p>
              </p:txBody>
            </p:sp>
            <p:sp>
              <p:nvSpPr>
                <p:cNvPr id="189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35AB84E-E188-9547-893D-328E595EF5CE}"/>
                    </a:ext>
                  </a:extLst>
                </p:cNvPr>
                <p:cNvSpPr txBox="1"/>
                <p:nvPr/>
              </p:nvSpPr>
              <p:spPr>
                <a:xfrm>
                  <a:off x="3256484" y="2309581"/>
                  <a:ext cx="318327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390)</a:t>
                  </a:r>
                </a:p>
              </p:txBody>
            </p:sp>
            <p:sp>
              <p:nvSpPr>
                <p:cNvPr id="190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8B6EB7-811A-AE4E-9C27-F521684EE821}"/>
                    </a:ext>
                  </a:extLst>
                </p:cNvPr>
                <p:cNvSpPr txBox="1"/>
                <p:nvPr/>
              </p:nvSpPr>
              <p:spPr>
                <a:xfrm>
                  <a:off x="3652024" y="2208748"/>
                  <a:ext cx="318327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277)</a:t>
                  </a:r>
                </a:p>
              </p:txBody>
            </p:sp>
            <p:sp>
              <p:nvSpPr>
                <p:cNvPr id="191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A37BFA0-2E06-6040-B456-A9042A8C3105}"/>
                    </a:ext>
                  </a:extLst>
                </p:cNvPr>
                <p:cNvSpPr txBox="1"/>
                <p:nvPr/>
              </p:nvSpPr>
              <p:spPr>
                <a:xfrm>
                  <a:off x="4033921" y="2208748"/>
                  <a:ext cx="318327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365)</a:t>
                  </a:r>
                </a:p>
              </p:txBody>
            </p:sp>
            <p:sp>
              <p:nvSpPr>
                <p:cNvPr id="192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6791CA1-9F61-6242-BC93-4EB73D2A0F77}"/>
                    </a:ext>
                  </a:extLst>
                </p:cNvPr>
                <p:cNvSpPr txBox="1"/>
                <p:nvPr/>
              </p:nvSpPr>
              <p:spPr>
                <a:xfrm>
                  <a:off x="4480227" y="2208748"/>
                  <a:ext cx="318327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394)</a:t>
                  </a:r>
                </a:p>
              </p:txBody>
            </p:sp>
            <p:sp>
              <p:nvSpPr>
                <p:cNvPr id="193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D441092-3F99-E645-84DC-DC94CD1F719C}"/>
                    </a:ext>
                  </a:extLst>
                </p:cNvPr>
                <p:cNvSpPr txBox="1"/>
                <p:nvPr/>
              </p:nvSpPr>
              <p:spPr>
                <a:xfrm>
                  <a:off x="5031762" y="2208748"/>
                  <a:ext cx="318327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394)</a:t>
                  </a:r>
                </a:p>
              </p:txBody>
            </p:sp>
            <p:grpSp>
              <p:nvGrpSpPr>
                <p:cNvPr id="195" name="Grouper 15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37B65F8-BD03-3D4F-A7E3-122F01FC6A76}"/>
                    </a:ext>
                  </a:extLst>
                </p:cNvPr>
                <p:cNvGrpSpPr/>
                <p:nvPr/>
              </p:nvGrpSpPr>
              <p:grpSpPr>
                <a:xfrm>
                  <a:off x="1148323" y="2066299"/>
                  <a:ext cx="424853" cy="280948"/>
                  <a:chOff x="1148323" y="2066299"/>
                  <a:chExt cx="424853" cy="280948"/>
                </a:xfrm>
              </p:grpSpPr>
              <p:sp>
                <p:nvSpPr>
                  <p:cNvPr id="196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CD1EFD1-FB12-0E48-91A1-DD85B5603B33}"/>
                      </a:ext>
                    </a:extLst>
                  </p:cNvPr>
                  <p:cNvSpPr txBox="1"/>
                  <p:nvPr/>
                </p:nvSpPr>
                <p:spPr>
                  <a:xfrm>
                    <a:off x="1251662" y="2087283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97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3E19A1F-27CE-6744-A2E1-BCF4C8FC4530}"/>
                      </a:ext>
                    </a:extLst>
                  </p:cNvPr>
                  <p:cNvSpPr txBox="1"/>
                  <p:nvPr/>
                </p:nvSpPr>
                <p:spPr>
                  <a:xfrm>
                    <a:off x="1201586" y="2208748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215)</a:t>
                    </a:r>
                  </a:p>
                </p:txBody>
              </p:sp>
              <p:cxnSp>
                <p:nvCxnSpPr>
                  <p:cNvPr id="198" name="Connecteur droit 19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62BB8D0-8F2A-0442-B870-F2F83C713916}"/>
                      </a:ext>
                    </a:extLst>
                  </p:cNvPr>
                  <p:cNvCxnSpPr/>
                  <p:nvPr/>
                </p:nvCxnSpPr>
                <p:spPr>
                  <a:xfrm>
                    <a:off x="1148323" y="2066299"/>
                    <a:ext cx="424853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9" name="Grouper 15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1286C3F-1148-0C4E-9D0E-2E4E4758CCC0}"/>
                    </a:ext>
                  </a:extLst>
                </p:cNvPr>
                <p:cNvGrpSpPr/>
                <p:nvPr/>
              </p:nvGrpSpPr>
              <p:grpSpPr>
                <a:xfrm>
                  <a:off x="1786116" y="2064543"/>
                  <a:ext cx="505265" cy="282704"/>
                  <a:chOff x="1786116" y="2064543"/>
                  <a:chExt cx="505265" cy="282704"/>
                </a:xfrm>
              </p:grpSpPr>
              <p:sp>
                <p:nvSpPr>
                  <p:cNvPr id="200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DEBD092-4681-BE4A-8B5E-D3277A4F585C}"/>
                      </a:ext>
                    </a:extLst>
                  </p:cNvPr>
                  <p:cNvSpPr txBox="1"/>
                  <p:nvPr/>
                </p:nvSpPr>
                <p:spPr>
                  <a:xfrm>
                    <a:off x="1929661" y="2087283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201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B864C7-531B-5245-BE3D-B72841B00F3D}"/>
                      </a:ext>
                    </a:extLst>
                  </p:cNvPr>
                  <p:cNvSpPr txBox="1"/>
                  <p:nvPr/>
                </p:nvSpPr>
                <p:spPr>
                  <a:xfrm>
                    <a:off x="1879585" y="2208748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510)</a:t>
                    </a:r>
                  </a:p>
                </p:txBody>
              </p:sp>
              <p:cxnSp>
                <p:nvCxnSpPr>
                  <p:cNvPr id="202" name="Connecteur droit 20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415DC4B-52E7-CF48-9947-B100425A3BAE}"/>
                      </a:ext>
                    </a:extLst>
                  </p:cNvPr>
                  <p:cNvCxnSpPr/>
                  <p:nvPr/>
                </p:nvCxnSpPr>
                <p:spPr>
                  <a:xfrm>
                    <a:off x="1786116" y="2064543"/>
                    <a:ext cx="505265" cy="3512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4" name="Grouper 15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CC01F77-045C-BE4F-884C-FD629F580AC9}"/>
                    </a:ext>
                  </a:extLst>
                </p:cNvPr>
                <p:cNvGrpSpPr/>
                <p:nvPr/>
              </p:nvGrpSpPr>
              <p:grpSpPr>
                <a:xfrm>
                  <a:off x="2377004" y="2066299"/>
                  <a:ext cx="433874" cy="280948"/>
                  <a:chOff x="2377004" y="2066299"/>
                  <a:chExt cx="433874" cy="280948"/>
                </a:xfrm>
              </p:grpSpPr>
              <p:sp>
                <p:nvSpPr>
                  <p:cNvPr id="205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E1A088D-B236-A140-8547-A848EAEC5B96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2510135" y="2087283"/>
                    <a:ext cx="16761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206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DFF1A11-2238-0044-93C7-2E7D030E869C}"/>
                      </a:ext>
                    </a:extLst>
                  </p:cNvPr>
                  <p:cNvSpPr txBox="1"/>
                  <p:nvPr/>
                </p:nvSpPr>
                <p:spPr>
                  <a:xfrm>
                    <a:off x="2434778" y="2208748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611)</a:t>
                    </a:r>
                  </a:p>
                </p:txBody>
              </p:sp>
              <p:cxnSp>
                <p:nvCxnSpPr>
                  <p:cNvPr id="207" name="Connecteur droit 20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A34ED3E-AFB1-084D-8309-17AF7A0CDE7F}"/>
                      </a:ext>
                    </a:extLst>
                  </p:cNvPr>
                  <p:cNvCxnSpPr/>
                  <p:nvPr/>
                </p:nvCxnSpPr>
                <p:spPr>
                  <a:xfrm>
                    <a:off x="2377004" y="2066299"/>
                    <a:ext cx="433874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9" name="Grouper 156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8C6F470-31DD-B04C-BF9A-7035DD1649C2}"/>
                    </a:ext>
                  </a:extLst>
                </p:cNvPr>
                <p:cNvGrpSpPr/>
                <p:nvPr/>
              </p:nvGrpSpPr>
              <p:grpSpPr>
                <a:xfrm>
                  <a:off x="2805183" y="2150348"/>
                  <a:ext cx="365035" cy="297732"/>
                  <a:chOff x="2805183" y="2150348"/>
                  <a:chExt cx="365035" cy="297732"/>
                </a:xfrm>
              </p:grpSpPr>
              <p:sp>
                <p:nvSpPr>
                  <p:cNvPr id="210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7DF6D70-7975-1A42-BFFC-A5656814DE63}"/>
                      </a:ext>
                    </a:extLst>
                  </p:cNvPr>
                  <p:cNvSpPr txBox="1"/>
                  <p:nvPr/>
                </p:nvSpPr>
                <p:spPr>
                  <a:xfrm>
                    <a:off x="2828537" y="2309581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402)</a:t>
                    </a:r>
                  </a:p>
                </p:txBody>
              </p:sp>
              <p:cxnSp>
                <p:nvCxnSpPr>
                  <p:cNvPr id="211" name="Connecteur droit 21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5E3E724-BBF0-5B4E-9C12-1F0B16E0C44C}"/>
                      </a:ext>
                    </a:extLst>
                  </p:cNvPr>
                  <p:cNvCxnSpPr/>
                  <p:nvPr/>
                </p:nvCxnSpPr>
                <p:spPr>
                  <a:xfrm>
                    <a:off x="2805183" y="2150348"/>
                    <a:ext cx="365035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2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944EA81-247B-F641-B354-3FEAD75CD224}"/>
                      </a:ext>
                    </a:extLst>
                  </p:cNvPr>
                  <p:cNvSpPr txBox="1"/>
                  <p:nvPr/>
                </p:nvSpPr>
                <p:spPr>
                  <a:xfrm>
                    <a:off x="2878613" y="2177315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</p:grpSp>
            <p:cxnSp>
              <p:nvCxnSpPr>
                <p:cNvPr id="213" name="Connecteur droit 21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1FE64F9-C942-AC45-B0C2-F56FE33083CD}"/>
                    </a:ext>
                  </a:extLst>
                </p:cNvPr>
                <p:cNvCxnSpPr/>
                <p:nvPr/>
              </p:nvCxnSpPr>
              <p:spPr>
                <a:xfrm>
                  <a:off x="3233130" y="2150348"/>
                  <a:ext cx="365035" cy="0"/>
                </a:xfrm>
                <a:prstGeom prst="line">
                  <a:avLst/>
                </a:prstGeom>
                <a:ln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4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E1325AA-AB29-4842-99E0-B1E8CB52B31C}"/>
                    </a:ext>
                  </a:extLst>
                </p:cNvPr>
                <p:cNvSpPr txBox="1"/>
                <p:nvPr/>
              </p:nvSpPr>
              <p:spPr>
                <a:xfrm>
                  <a:off x="3306560" y="2177315"/>
                  <a:ext cx="218174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cxnSp>
              <p:nvCxnSpPr>
                <p:cNvPr id="215" name="Connecteur droit 21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A26BA3-C7BC-5A49-8F14-4BB80B933308}"/>
                    </a:ext>
                  </a:extLst>
                </p:cNvPr>
                <p:cNvCxnSpPr/>
                <p:nvPr/>
              </p:nvCxnSpPr>
              <p:spPr>
                <a:xfrm>
                  <a:off x="3667188" y="2066299"/>
                  <a:ext cx="287999" cy="0"/>
                </a:xfrm>
                <a:prstGeom prst="line">
                  <a:avLst/>
                </a:prstGeom>
                <a:ln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6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F68F263-A74B-7141-9512-03B1AF6BB86B}"/>
                    </a:ext>
                  </a:extLst>
                </p:cNvPr>
                <p:cNvSpPr txBox="1"/>
                <p:nvPr/>
              </p:nvSpPr>
              <p:spPr>
                <a:xfrm>
                  <a:off x="3702100" y="2087283"/>
                  <a:ext cx="218174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cxnSp>
              <p:nvCxnSpPr>
                <p:cNvPr id="217" name="Connecteur droit 216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7A0B95F-21DB-C14C-AC7C-0F143B9FCBF0}"/>
                    </a:ext>
                  </a:extLst>
                </p:cNvPr>
                <p:cNvCxnSpPr/>
                <p:nvPr/>
              </p:nvCxnSpPr>
              <p:spPr>
                <a:xfrm>
                  <a:off x="4010567" y="2066299"/>
                  <a:ext cx="365035" cy="0"/>
                </a:xfrm>
                <a:prstGeom prst="line">
                  <a:avLst/>
                </a:prstGeom>
                <a:ln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8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D48B0F7-8DDB-854C-ABA6-1398A60DF59D}"/>
                    </a:ext>
                  </a:extLst>
                </p:cNvPr>
                <p:cNvSpPr txBox="1"/>
                <p:nvPr/>
              </p:nvSpPr>
              <p:spPr>
                <a:xfrm>
                  <a:off x="4083997" y="2087283"/>
                  <a:ext cx="218174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cxnSp>
              <p:nvCxnSpPr>
                <p:cNvPr id="219" name="Connecteur droit 218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41E153E-F188-BC49-A86E-2AC18582F891}"/>
                    </a:ext>
                  </a:extLst>
                </p:cNvPr>
                <p:cNvCxnSpPr/>
                <p:nvPr/>
              </p:nvCxnSpPr>
              <p:spPr>
                <a:xfrm>
                  <a:off x="4456873" y="2066299"/>
                  <a:ext cx="365035" cy="0"/>
                </a:xfrm>
                <a:prstGeom prst="line">
                  <a:avLst/>
                </a:prstGeom>
                <a:ln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0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8B3C303-9B4C-BC47-BC08-2CD12880A73B}"/>
                    </a:ext>
                  </a:extLst>
                </p:cNvPr>
                <p:cNvSpPr txBox="1"/>
                <p:nvPr/>
              </p:nvSpPr>
              <p:spPr>
                <a:xfrm>
                  <a:off x="4530303" y="2087283"/>
                  <a:ext cx="218174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cxnSp>
              <p:nvCxnSpPr>
                <p:cNvPr id="221" name="Connecteur droit 220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327E25F-3745-A344-AB37-E7CDED2FCD32}"/>
                    </a:ext>
                  </a:extLst>
                </p:cNvPr>
                <p:cNvCxnSpPr/>
                <p:nvPr/>
              </p:nvCxnSpPr>
              <p:spPr>
                <a:xfrm>
                  <a:off x="4992926" y="2066299"/>
                  <a:ext cx="395998" cy="0"/>
                </a:xfrm>
                <a:prstGeom prst="line">
                  <a:avLst/>
                </a:prstGeom>
                <a:ln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2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2F6765F-E71B-4D4C-87AF-A67C4FB16227}"/>
                    </a:ext>
                  </a:extLst>
                </p:cNvPr>
                <p:cNvSpPr txBox="1"/>
                <p:nvPr/>
              </p:nvSpPr>
              <p:spPr>
                <a:xfrm>
                  <a:off x="5081838" y="2087283"/>
                  <a:ext cx="218174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</p:grpSp>
          <p:sp>
            <p:nvSpPr>
              <p:cNvPr id="6" name="ZoneTexte 5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8CD09EB-C03B-F54A-B68B-13C953E1139E}"/>
                  </a:ext>
                </a:extLst>
              </p:cNvPr>
              <p:cNvSpPr txBox="1"/>
              <p:nvPr/>
            </p:nvSpPr>
            <p:spPr>
              <a:xfrm>
                <a:off x="-29902" y="-2377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grpSp>
          <p:nvGrpSpPr>
            <p:cNvPr id="31" name="Groupe 30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674CC96-F2AB-9B47-AA6F-8CB79D66D410}"/>
                </a:ext>
              </a:extLst>
            </p:cNvPr>
            <p:cNvGrpSpPr/>
            <p:nvPr/>
          </p:nvGrpSpPr>
          <p:grpSpPr>
            <a:xfrm>
              <a:off x="-50482" y="1507025"/>
              <a:ext cx="6908482" cy="3832618"/>
              <a:chOff x="-50482" y="1507025"/>
              <a:chExt cx="6908482" cy="3832618"/>
            </a:xfrm>
          </p:grpSpPr>
          <p:grpSp>
            <p:nvGrpSpPr>
              <p:cNvPr id="30" name="Groupe 29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6F74F2F-A95E-8B4F-9BBE-FD3E567F9832}"/>
                  </a:ext>
                </a:extLst>
              </p:cNvPr>
              <p:cNvGrpSpPr/>
              <p:nvPr/>
            </p:nvGrpSpPr>
            <p:grpSpPr>
              <a:xfrm>
                <a:off x="-50482" y="1599123"/>
                <a:ext cx="6908482" cy="3740520"/>
                <a:chOff x="-50482" y="1599123"/>
                <a:chExt cx="6908482" cy="3740520"/>
              </a:xfrm>
            </p:grpSpPr>
            <p:grpSp>
              <p:nvGrpSpPr>
                <p:cNvPr id="99" name="Groupe 98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DAAFADC-425F-3F42-A234-6727E97F4D3C}"/>
                    </a:ext>
                  </a:extLst>
                </p:cNvPr>
                <p:cNvGrpSpPr/>
                <p:nvPr/>
              </p:nvGrpSpPr>
              <p:grpSpPr>
                <a:xfrm>
                  <a:off x="1312981" y="1599123"/>
                  <a:ext cx="1458518" cy="1837212"/>
                  <a:chOff x="1457774" y="2755697"/>
                  <a:chExt cx="1458518" cy="1837212"/>
                </a:xfrm>
              </p:grpSpPr>
              <p:grpSp>
                <p:nvGrpSpPr>
                  <p:cNvPr id="92" name="Groupe 9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895A1F0-60C1-074C-B6A6-A51DC6D6A418}"/>
                      </a:ext>
                    </a:extLst>
                  </p:cNvPr>
                  <p:cNvGrpSpPr/>
                  <p:nvPr/>
                </p:nvGrpSpPr>
                <p:grpSpPr>
                  <a:xfrm>
                    <a:off x="1457774" y="3719879"/>
                    <a:ext cx="411695" cy="743797"/>
                    <a:chOff x="2003399" y="3735751"/>
                    <a:chExt cx="411695" cy="743797"/>
                  </a:xfrm>
                </p:grpSpPr>
                <p:cxnSp>
                  <p:nvCxnSpPr>
                    <p:cNvPr id="246" name="Connecteur droit avec flèche 24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3A7BB88-E343-4C42-B5C4-15A44DF8748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307094" y="4390357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47" name="Rectangle 24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D1417E1-958C-BD48-AA76-AA439F3E724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25039" y="4294882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49" name="Connecteur droit avec flèche 24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074DCFD-40A6-D34B-8108-D3B3A5002EB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307094" y="4271210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0" name="Rectangle 24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ED97E93-5368-3F45-B96F-F978961FB03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25039" y="4181066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6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52" name="Connecteur droit avec flèche 25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3D5110F-8E90-C340-B70C-686A363FA5C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307094" y="4126631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3" name="Rectangle 25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83E8D4F-97CA-244D-A119-EB25A7F9020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25039" y="4028869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8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55" name="Rectangle 25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36D5339-EB21-2C4A-88AD-23CF5F777D1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03399" y="3925650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0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256" name="Groupe 25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BD3316C-7EAC-F84E-BF98-B846637D92C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275266" y="4030809"/>
                      <a:ext cx="139828" cy="49020"/>
                      <a:chOff x="309969" y="3663002"/>
                      <a:chExt cx="139828" cy="49020"/>
                    </a:xfrm>
                  </p:grpSpPr>
                  <p:cxnSp>
                    <p:nvCxnSpPr>
                      <p:cNvPr id="257" name="Connecteur droit avec flèche 25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5345456-18C2-124C-BE17-1B4D67AB299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1129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58" name="Connecteur droit avec flèche 25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43A379A-1E14-5B42-B39B-2B20E0502BC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 flipV="1">
                        <a:off x="309969" y="3663002"/>
                        <a:ext cx="36000" cy="4902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260" name="Connecteur droit avec flèche 25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7FA02AA-7A0B-974F-9043-E7CE6370ABB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307094" y="3939051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1" name="Rectangle 26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ECD84CC-7913-734D-AC18-24AB2E0709D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03399" y="3845499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5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63" name="Connecteur droit avec flèche 26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996C614-1893-C748-B9C0-6E6006CBC21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307094" y="3833716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4" name="Rectangle 26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AF7380D-0A50-8648-8FF0-A0E1D2488AB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03399" y="3735751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0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93" name="Groupe 9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3C39D7A-5919-BE4E-8C5C-7F6A61414AA5}"/>
                      </a:ext>
                    </a:extLst>
                  </p:cNvPr>
                  <p:cNvGrpSpPr/>
                  <p:nvPr/>
                </p:nvGrpSpPr>
                <p:grpSpPr>
                  <a:xfrm>
                    <a:off x="2018570" y="2755697"/>
                    <a:ext cx="897722" cy="586692"/>
                    <a:chOff x="2018570" y="2755697"/>
                    <a:chExt cx="897722" cy="586692"/>
                  </a:xfrm>
                </p:grpSpPr>
                <p:sp>
                  <p:nvSpPr>
                    <p:cNvPr id="268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BBC48F2-2C99-E948-A7B9-36B426D6A1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18570" y="3219278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69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A4EF56-CDE6-174F-B3ED-1D76AE1A57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44255" y="2755697"/>
                      <a:ext cx="84171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(510 </a:t>
                      </a:r>
                      <a:r>
                        <a:rPr lang="en-US" sz="9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bp</a:t>
                      </a: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)</a:t>
                      </a:r>
                    </a:p>
                  </p:txBody>
                </p:sp>
                <p:sp>
                  <p:nvSpPr>
                    <p:cNvPr id="270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DFD5D10-8E24-4A41-980F-A3D5B901B1A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77721" y="3108844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71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34C336A-B861-C548-900C-20DB8BE4AB8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17007" y="3219278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  <p:sp>
                  <p:nvSpPr>
                    <p:cNvPr id="272" name="Parenthèse ouvrante 27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D315197-A186-CB4B-82EB-6E75FD1F16EC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2445706" y="2666597"/>
                      <a:ext cx="45719" cy="800138"/>
                    </a:xfrm>
                    <a:prstGeom prst="leftBracket">
                      <a:avLst/>
                    </a:prstGeom>
                    <a:ln w="1905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/>
                        <a:cs typeface="Arial"/>
                      </a:endParaRPr>
                    </a:p>
                  </p:txBody>
                </p:sp>
              </p:grpSp>
              <p:pic>
                <p:nvPicPr>
                  <p:cNvPr id="230" name="Image 22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7525596-CEA8-F34C-B9A7-840DB476829C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1831969" y="3332909"/>
                    <a:ext cx="1044000" cy="12600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285" name="Groupe 28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8852353-0627-3249-A130-F0A51D3C6D43}"/>
                    </a:ext>
                  </a:extLst>
                </p:cNvPr>
                <p:cNvGrpSpPr/>
                <p:nvPr/>
              </p:nvGrpSpPr>
              <p:grpSpPr>
                <a:xfrm>
                  <a:off x="2677635" y="1599123"/>
                  <a:ext cx="1469477" cy="1835332"/>
                  <a:chOff x="3047634" y="2733752"/>
                  <a:chExt cx="1469477" cy="1835332"/>
                </a:xfrm>
              </p:grpSpPr>
              <p:grpSp>
                <p:nvGrpSpPr>
                  <p:cNvPr id="137" name="Groupe 13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AF6773B-08B9-3F49-BEDA-58A308535281}"/>
                      </a:ext>
                    </a:extLst>
                  </p:cNvPr>
                  <p:cNvGrpSpPr/>
                  <p:nvPr/>
                </p:nvGrpSpPr>
                <p:grpSpPr>
                  <a:xfrm>
                    <a:off x="3047634" y="3751238"/>
                    <a:ext cx="417610" cy="772314"/>
                    <a:chOff x="3047634" y="3751238"/>
                    <a:chExt cx="417610" cy="772314"/>
                  </a:xfrm>
                </p:grpSpPr>
                <p:cxnSp>
                  <p:nvCxnSpPr>
                    <p:cNvPr id="112" name="Connecteur droit avec flèche 11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4B0C16E-7815-AA41-A3D3-9B046BB1126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341330" y="4426334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3" name="Rectangle 11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578775C-B4FA-F542-88F5-0A4ACA9DEF9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69274" y="4338886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115" name="Connecteur droit avec flèche 11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EFD55DF-0750-254C-BF98-120169DA656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341330" y="4283988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6" name="Rectangle 11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E2FBB57-C3B7-CB4C-996E-C46B007815C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69274" y="4195578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118" name="Connecteur droit avec flèche 11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A42EF93-486F-EA40-A878-16319681511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341330" y="4158572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9" name="Rectangle 11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39E2807-EB49-8E4E-A17D-424D141F374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69274" y="4063700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6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21" name="Rectangle 12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28D145F-9393-904D-BDF7-A0AFEB0E650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47634" y="3852419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0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122" name="Groupe 12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F06DE6C-CD16-124F-8B85-53FD0D99769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325416" y="3944414"/>
                      <a:ext cx="139828" cy="49020"/>
                      <a:chOff x="309969" y="3663002"/>
                      <a:chExt cx="139828" cy="49020"/>
                    </a:xfrm>
                  </p:grpSpPr>
                  <p:cxnSp>
                    <p:nvCxnSpPr>
                      <p:cNvPr id="123" name="Connecteur droit avec flèche 12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E34598E-AD18-294A-BE63-9F614524CEE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1129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24" name="Connecteur droit avec flèche 12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FA763B3-2D9A-7F47-820E-A6D43A0FEDC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 flipV="1">
                        <a:off x="309969" y="3663002"/>
                        <a:ext cx="36000" cy="4902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126" name="Connecteur droit avec flèche 1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8C5E694-06B4-1747-84B1-99C2D102595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341330" y="3853330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27" name="Rectangle 12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BA6ED3B-F199-E548-9BB4-29A05DE8F08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47634" y="3751238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5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74" name="Connecteur droit avec flèche 27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D0DCBE8-403C-F540-8113-9CB5B400492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341330" y="4076572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75" name="Rectangle 27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E64E971-1CB3-8F4A-BD4C-C6B8FABF582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69274" y="3981700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8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</p:grpSp>
              <p:pic>
                <p:nvPicPr>
                  <p:cNvPr id="236" name="Image 235" descr="D:\Articles Samuel\Gel\GelDocXRPlus 2019-01-08 17hr 43min.jpg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85FBD2F-51DE-DB45-9BF3-5F4FFFFB09E2}"/>
                      </a:ext>
                    </a:extLst>
                  </p:cNvPr>
                  <p:cNvPicPr/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  </a:ext>
                    </a:extLst>
                  </a:blip>
                  <a:srcRect l="40108" t="25399" r="36225" b="50160"/>
                  <a:stretch/>
                </p:blipFill>
                <p:spPr bwMode="auto">
                  <a:xfrm>
                    <a:off x="3404318" y="3309084"/>
                    <a:ext cx="1044000" cy="12600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53640926-AAD7-44d8-BBD7-CCE9431645EC}">
                      <a14:shadowObscured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="" xmlns:mv="urn:schemas-microsoft-com:mac:vml" xmlns:mc="http://schemas.openxmlformats.org/markup-compatibility/2006"/>
                    </a:ext>
                  </a:extLst>
                </p:spPr>
              </p:pic>
              <p:sp>
                <p:nvSpPr>
                  <p:cNvPr id="280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792F4B9-AC83-C847-9A2A-4CC5CFBFB7D8}"/>
                      </a:ext>
                    </a:extLst>
                  </p:cNvPr>
                  <p:cNvSpPr txBox="1"/>
                  <p:nvPr/>
                </p:nvSpPr>
                <p:spPr>
                  <a:xfrm>
                    <a:off x="3619389" y="3172814"/>
                    <a:ext cx="41782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g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81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9AC3FE8-E947-9A42-96F3-ECA6DB4121E8}"/>
                      </a:ext>
                    </a:extLst>
                  </p:cNvPr>
                  <p:cNvSpPr txBox="1"/>
                  <p:nvPr/>
                </p:nvSpPr>
                <p:spPr>
                  <a:xfrm>
                    <a:off x="3645074" y="2733752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3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611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sp>
                <p:nvSpPr>
                  <p:cNvPr id="282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1BB80DB-FD13-5D4D-A757-E004543C759C}"/>
                      </a:ext>
                    </a:extLst>
                  </p:cNvPr>
                  <p:cNvSpPr txBox="1"/>
                  <p:nvPr/>
                </p:nvSpPr>
                <p:spPr>
                  <a:xfrm>
                    <a:off x="3850567" y="3062380"/>
                    <a:ext cx="39193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83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6A0CA9A-081B-FE48-880D-14B0F1D20250}"/>
                      </a:ext>
                    </a:extLst>
                  </p:cNvPr>
                  <p:cNvSpPr txBox="1"/>
                  <p:nvPr/>
                </p:nvSpPr>
                <p:spPr>
                  <a:xfrm>
                    <a:off x="4217826" y="3172814"/>
                    <a:ext cx="299285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RNA</a:t>
                    </a:r>
                  </a:p>
                </p:txBody>
              </p:sp>
              <p:sp>
                <p:nvSpPr>
                  <p:cNvPr id="284" name="Parenthèse ouvrante 28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1A5B60-0992-454D-97E2-E9E0C8207FD0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4046525" y="2644652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346" name="Groupe 34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2788313-64DF-0B4C-83AD-EA35787D5F57}"/>
                    </a:ext>
                  </a:extLst>
                </p:cNvPr>
                <p:cNvGrpSpPr/>
                <p:nvPr/>
              </p:nvGrpSpPr>
              <p:grpSpPr>
                <a:xfrm>
                  <a:off x="4028712" y="1599123"/>
                  <a:ext cx="1458271" cy="1835735"/>
                  <a:chOff x="4918458" y="2763012"/>
                  <a:chExt cx="1458271" cy="1835735"/>
                </a:xfrm>
              </p:grpSpPr>
              <p:cxnSp>
                <p:nvCxnSpPr>
                  <p:cNvPr id="309" name="Connecteur droit avec flèche 30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130BCE3-4451-BD4D-BD73-2C75083AB6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215678" y="4400987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0" name="Rectangle 30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E8F9ADA-CB06-9A4F-ABDA-F61A903B383E}"/>
                      </a:ext>
                    </a:extLst>
                  </p:cNvPr>
                  <p:cNvSpPr/>
                  <p:nvPr/>
                </p:nvSpPr>
                <p:spPr>
                  <a:xfrm>
                    <a:off x="4940098" y="4298412"/>
                    <a:ext cx="31451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4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312" name="Connecteur droit avec flèche 31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7A3A78E-0B8C-2643-8625-A9E05770F01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215678" y="4271570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3" name="Rectangle 31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E3209A7-DCAA-E741-87CC-362E11101F33}"/>
                      </a:ext>
                    </a:extLst>
                  </p:cNvPr>
                  <p:cNvSpPr/>
                  <p:nvPr/>
                </p:nvSpPr>
                <p:spPr>
                  <a:xfrm>
                    <a:off x="4940098" y="4166015"/>
                    <a:ext cx="31451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6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315" name="Connecteur droit avec flèche 31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12227AE-5DA2-5544-B046-770C8969E5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215678" y="4160017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6" name="Rectangle 31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5BB8F21-79E9-5E44-A924-63B8A2B1CFBC}"/>
                      </a:ext>
                    </a:extLst>
                  </p:cNvPr>
                  <p:cNvSpPr/>
                  <p:nvPr/>
                </p:nvSpPr>
                <p:spPr>
                  <a:xfrm>
                    <a:off x="4940098" y="4063466"/>
                    <a:ext cx="31451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8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18" name="Rectangle 31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799E508-24D0-8E4D-A071-24EB216F0DBB}"/>
                      </a:ext>
                    </a:extLst>
                  </p:cNvPr>
                  <p:cNvSpPr/>
                  <p:nvPr/>
                </p:nvSpPr>
                <p:spPr>
                  <a:xfrm>
                    <a:off x="4918458" y="3942443"/>
                    <a:ext cx="35779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0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319" name="Groupe 31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F454970-2FF6-A347-80EA-CE6B6F61BBDC}"/>
                      </a:ext>
                    </a:extLst>
                  </p:cNvPr>
                  <p:cNvGrpSpPr/>
                  <p:nvPr/>
                </p:nvGrpSpPr>
                <p:grpSpPr>
                  <a:xfrm>
                    <a:off x="5185767" y="4038563"/>
                    <a:ext cx="137911" cy="49020"/>
                    <a:chOff x="611809" y="3665448"/>
                    <a:chExt cx="137911" cy="49020"/>
                  </a:xfrm>
                </p:grpSpPr>
                <p:cxnSp>
                  <p:nvCxnSpPr>
                    <p:cNvPr id="320" name="Connecteur droit avec flèche 31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F99FA6E-245F-FF40-95E8-9432598F731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641720" y="3711293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1" name="Connecteur droit avec flèche 32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68A79BB-0668-0245-81CF-CA0F7B427BB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 flipV="1">
                      <a:off x="611809" y="3665448"/>
                      <a:ext cx="36000" cy="4902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23" name="Connecteur droit avec flèche 32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BEE4CE1-FAA0-1D45-B1B2-D5618D910D7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215678" y="3936227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4" name="Rectangle 32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5BE6F0E-85E7-4949-9858-2AB1F96670DA}"/>
                      </a:ext>
                    </a:extLst>
                  </p:cNvPr>
                  <p:cNvSpPr/>
                  <p:nvPr/>
                </p:nvSpPr>
                <p:spPr>
                  <a:xfrm>
                    <a:off x="4918458" y="3816990"/>
                    <a:ext cx="35779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5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331" name="Connecteur droit avec flèche 33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F964B2-BE1B-E04E-A970-E37AD3FC8CC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215678" y="3805693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2" name="Rectangle 33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F147900-965B-E74C-849F-B644D7E1457E}"/>
                      </a:ext>
                    </a:extLst>
                  </p:cNvPr>
                  <p:cNvSpPr/>
                  <p:nvPr/>
                </p:nvSpPr>
                <p:spPr>
                  <a:xfrm>
                    <a:off x="4918458" y="3713360"/>
                    <a:ext cx="35779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20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pic>
                <p:nvPicPr>
                  <p:cNvPr id="286" name="Image 28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5C2559D-E180-2F4F-8941-275C74F24285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4"/>
                  <a:srcRect b="11531"/>
                  <a:stretch/>
                </p:blipFill>
                <p:spPr>
                  <a:xfrm>
                    <a:off x="5291210" y="3338747"/>
                    <a:ext cx="1044000" cy="1260000"/>
                  </a:xfrm>
                  <a:prstGeom prst="rect">
                    <a:avLst/>
                  </a:prstGeom>
                </p:spPr>
              </p:pic>
              <p:sp>
                <p:nvSpPr>
                  <p:cNvPr id="340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1D187AC-AE43-6A40-B73D-7ECD2DE85573}"/>
                      </a:ext>
                    </a:extLst>
                  </p:cNvPr>
                  <p:cNvSpPr txBox="1"/>
                  <p:nvPr/>
                </p:nvSpPr>
                <p:spPr>
                  <a:xfrm>
                    <a:off x="5509329" y="3187802"/>
                    <a:ext cx="41782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g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41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916DF8F-3089-4346-9808-FB78E2568155}"/>
                      </a:ext>
                    </a:extLst>
                  </p:cNvPr>
                  <p:cNvSpPr txBox="1"/>
                  <p:nvPr/>
                </p:nvSpPr>
                <p:spPr>
                  <a:xfrm>
                    <a:off x="5535014" y="2763012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4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402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sp>
                <p:nvSpPr>
                  <p:cNvPr id="342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41376AD-5E5F-EE46-91D9-4F76E11110E4}"/>
                      </a:ext>
                    </a:extLst>
                  </p:cNvPr>
                  <p:cNvSpPr txBox="1"/>
                  <p:nvPr/>
                </p:nvSpPr>
                <p:spPr>
                  <a:xfrm>
                    <a:off x="5768480" y="3077368"/>
                    <a:ext cx="39193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43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D5CF8EF-4C05-044D-9B96-6C70FE45B86B}"/>
                      </a:ext>
                    </a:extLst>
                  </p:cNvPr>
                  <p:cNvSpPr txBox="1"/>
                  <p:nvPr/>
                </p:nvSpPr>
                <p:spPr>
                  <a:xfrm>
                    <a:off x="6063876" y="3187802"/>
                    <a:ext cx="299285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RNA</a:t>
                    </a:r>
                  </a:p>
                </p:txBody>
              </p:sp>
              <p:sp>
                <p:nvSpPr>
                  <p:cNvPr id="344" name="Parenthèse ouvrante 34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9F82EF0-E467-C140-8D4C-84B6E4C37FD5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5936465" y="2673912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29" name="Groupe 28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69B93BF-C43C-1E46-92AA-4AA756E37A32}"/>
                    </a:ext>
                  </a:extLst>
                </p:cNvPr>
                <p:cNvGrpSpPr/>
                <p:nvPr/>
              </p:nvGrpSpPr>
              <p:grpSpPr>
                <a:xfrm>
                  <a:off x="5369965" y="1599123"/>
                  <a:ext cx="1488035" cy="1841470"/>
                  <a:chOff x="5369965" y="1599123"/>
                  <a:chExt cx="1488035" cy="1841470"/>
                </a:xfrm>
              </p:grpSpPr>
              <p:sp>
                <p:nvSpPr>
                  <p:cNvPr id="372" name="Parenthèse ouvrante 37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D6F308B-0D0F-364F-97C9-C4F44E0C664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6435071" y="1510023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373" name="Groupe 37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C2FF91A-9FBC-5342-A430-9D210C286738}"/>
                      </a:ext>
                    </a:extLst>
                  </p:cNvPr>
                  <p:cNvGrpSpPr/>
                  <p:nvPr/>
                </p:nvGrpSpPr>
                <p:grpSpPr>
                  <a:xfrm>
                    <a:off x="5369965" y="1599123"/>
                    <a:ext cx="1477172" cy="1841470"/>
                    <a:chOff x="5381890" y="2763012"/>
                    <a:chExt cx="1477172" cy="1841470"/>
                  </a:xfrm>
                </p:grpSpPr>
                <p:grpSp>
                  <p:nvGrpSpPr>
                    <p:cNvPr id="367" name="Groupe 36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AB0BFCF-0750-3440-A0C3-F8ED855735B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81890" y="3344482"/>
                      <a:ext cx="1427110" cy="1260000"/>
                      <a:chOff x="5381890" y="3344482"/>
                      <a:chExt cx="1427110" cy="1260000"/>
                    </a:xfrm>
                  </p:grpSpPr>
                  <p:cxnSp>
                    <p:nvCxnSpPr>
                      <p:cNvPr id="348" name="Connecteur droit avec flèche 34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C339D6F-D351-F44B-B6FA-9312030CF7B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5693901" y="4380528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49" name="Rectangle 34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272FA02-E6E0-954F-B6B8-3A8365D0EA8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03530" y="4277953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4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cxnSp>
                    <p:nvCxnSpPr>
                      <p:cNvPr id="351" name="Connecteur droit avec flèche 35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483EF8B-BF57-044B-A215-F4F88268B18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5693901" y="4251109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52" name="Rectangle 35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A5AA5FC-E7C0-304D-B14B-104F5B85956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03530" y="4145554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cxnSp>
                    <p:nvCxnSpPr>
                      <p:cNvPr id="354" name="Connecteur droit avec flèche 35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A3A87E3-AA6E-B342-B551-8D4751E00EE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5693901" y="4161502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55" name="Rectangle 35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6E50160-155D-314C-B1AE-FB32FE6B9E0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403530" y="4064951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8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sp>
                    <p:nvSpPr>
                      <p:cNvPr id="357" name="Rectangle 35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757EFD2-A77F-EE4C-A99D-2B33661F537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81890" y="3921981"/>
                        <a:ext cx="35779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0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grpSp>
                    <p:nvGrpSpPr>
                      <p:cNvPr id="358" name="Groupe 35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8E098F9-29D8-354A-823A-C4C970993C0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663990" y="4018101"/>
                        <a:ext cx="137911" cy="49020"/>
                        <a:chOff x="311886" y="3738598"/>
                        <a:chExt cx="137911" cy="49020"/>
                      </a:xfrm>
                    </p:grpSpPr>
                    <p:cxnSp>
                      <p:nvCxnSpPr>
                        <p:cNvPr id="359" name="Connecteur droit avec flèche 35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675BB77-D758-F64C-9546-F42E94920BC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341797" y="378444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360" name="Connecteur droit avec flèche 35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556E0F3-7F5E-B748-B98B-A321D0C910D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311886" y="3738598"/>
                          <a:ext cx="36000" cy="4902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362" name="Connecteur droit avec flèche 36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02B1535-AE62-4649-A6E1-12C59DF08CA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5693901" y="3937710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63" name="Rectangle 36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7878B4C-A314-394A-88E6-FC4FB2BA19F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81890" y="3818473"/>
                        <a:ext cx="35779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5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pic>
                    <p:nvPicPr>
                      <p:cNvPr id="292" name="Image 29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1136962-604A-E549-B069-64A9CE98B32E}"/>
                          </a:ext>
                        </a:extLst>
                      </p:cNvPr>
                      <p:cNvPicPr preferRelativeResize="0">
                        <a:picLocks/>
                      </p:cNvPicPr>
                      <p:nvPr/>
                    </p:nvPicPr>
                    <p:blipFill rotWithShape="1">
                      <a:blip r:embed="rId5"/>
                      <a:srcRect b="14442"/>
                      <a:stretch/>
                    </p:blipFill>
                    <p:spPr>
                      <a:xfrm>
                        <a:off x="5765000" y="3344482"/>
                        <a:ext cx="1044000" cy="1260000"/>
                      </a:xfrm>
                      <a:prstGeom prst="rect">
                        <a:avLst/>
                      </a:prstGeom>
                    </p:spPr>
                  </p:pic>
                </p:grpSp>
                <p:sp>
                  <p:nvSpPr>
                    <p:cNvPr id="368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3D8046E-5A7A-DB4E-8829-45760F28DFB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90600" y="3212578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69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08E8AE8-A308-8346-85A8-A8F2488F191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16285" y="2763012"/>
                      <a:ext cx="84171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5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(390 </a:t>
                      </a:r>
                      <a:r>
                        <a:rPr lang="en-US" sz="9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bp</a:t>
                      </a: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)</a:t>
                      </a:r>
                    </a:p>
                  </p:txBody>
                </p:sp>
                <p:sp>
                  <p:nvSpPr>
                    <p:cNvPr id="370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C67EE41-2DB6-7643-B4D2-EA739DEF5CB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20491" y="3102144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71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7665E43-EE19-AC46-AE9C-385A1DC510D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59777" y="3212578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</p:grpSp>
            <p:grpSp>
              <p:nvGrpSpPr>
                <p:cNvPr id="495" name="Groupe 49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1C75C37-A6E3-E746-B449-CEE03CA077E1}"/>
                    </a:ext>
                  </a:extLst>
                </p:cNvPr>
                <p:cNvGrpSpPr/>
                <p:nvPr/>
              </p:nvGrpSpPr>
              <p:grpSpPr>
                <a:xfrm>
                  <a:off x="-50482" y="3534972"/>
                  <a:ext cx="1446966" cy="1803640"/>
                  <a:chOff x="-67817" y="4811401"/>
                  <a:chExt cx="1446966" cy="1803640"/>
                </a:xfrm>
              </p:grpSpPr>
              <p:cxnSp>
                <p:nvCxnSpPr>
                  <p:cNvPr id="375" name="Connecteur droit avec flèche 37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39C53F0-9128-3C48-B469-D6847B11723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29724" y="6408064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76" name="Rectangle 37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EB921A0-6611-324D-8B14-3891FD0BB048}"/>
                      </a:ext>
                    </a:extLst>
                  </p:cNvPr>
                  <p:cNvSpPr/>
                  <p:nvPr/>
                </p:nvSpPr>
                <p:spPr>
                  <a:xfrm>
                    <a:off x="-46177" y="6305489"/>
                    <a:ext cx="31451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4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378" name="Connecteur droit avec flèche 37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E71D615-2F5C-3F4C-A427-6A1697E613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29724" y="6266647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79" name="Rectangle 37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05EEBC0-21AF-154D-9695-0F245516962C}"/>
                      </a:ext>
                    </a:extLst>
                  </p:cNvPr>
                  <p:cNvSpPr/>
                  <p:nvPr/>
                </p:nvSpPr>
                <p:spPr>
                  <a:xfrm>
                    <a:off x="-46177" y="6161092"/>
                    <a:ext cx="31451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6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381" name="Connecteur droit avec flèche 38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0AA1B78-8ECD-5944-9105-8EB12306FEA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29724" y="6188561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82" name="Rectangle 38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7B7261C-2770-4948-B018-4B52C67F33CB}"/>
                      </a:ext>
                    </a:extLst>
                  </p:cNvPr>
                  <p:cNvSpPr/>
                  <p:nvPr/>
                </p:nvSpPr>
                <p:spPr>
                  <a:xfrm>
                    <a:off x="-46177" y="6092010"/>
                    <a:ext cx="31451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8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84" name="Rectangle 38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6ECDBC2-C59E-9B4F-A636-6523960B91CD}"/>
                      </a:ext>
                    </a:extLst>
                  </p:cNvPr>
                  <p:cNvSpPr/>
                  <p:nvPr/>
                </p:nvSpPr>
                <p:spPr>
                  <a:xfrm>
                    <a:off x="-67817" y="5978783"/>
                    <a:ext cx="35779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0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385" name="Groupe 38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4E82637-8015-3643-8C02-513BADDF0C1A}"/>
                      </a:ext>
                    </a:extLst>
                  </p:cNvPr>
                  <p:cNvGrpSpPr/>
                  <p:nvPr/>
                </p:nvGrpSpPr>
                <p:grpSpPr>
                  <a:xfrm>
                    <a:off x="199813" y="6074903"/>
                    <a:ext cx="137911" cy="49020"/>
                    <a:chOff x="311886" y="3665448"/>
                    <a:chExt cx="137911" cy="49020"/>
                  </a:xfrm>
                </p:grpSpPr>
                <p:cxnSp>
                  <p:nvCxnSpPr>
                    <p:cNvPr id="386" name="Connecteur droit avec flèche 38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E553289-81B3-9944-BADF-66F37D9D16D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41797" y="3711293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7" name="Connecteur droit avec flèche 38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444A347-FE91-4F4B-9CEA-D0C6547DF9C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 flipV="1">
                      <a:off x="311886" y="3665448"/>
                      <a:ext cx="36000" cy="4902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89" name="Connecteur droit avec flèche 38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682D35E-D44A-0E4F-B76B-66EDADCAD99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29724" y="5979363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90" name="Rectangle 38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C0B3C83-10AD-AB4B-B6FA-CBA2D0B69F59}"/>
                      </a:ext>
                    </a:extLst>
                  </p:cNvPr>
                  <p:cNvSpPr/>
                  <p:nvPr/>
                </p:nvSpPr>
                <p:spPr>
                  <a:xfrm>
                    <a:off x="-67817" y="5860126"/>
                    <a:ext cx="35779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5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395" name="Connecteur droit avec flèche 39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B6D71C5-451C-A94B-A443-57B5B9E410A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29724" y="5861103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96" name="Rectangle 39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6FEC494-8456-EA4E-BA16-9CFB09EE4644}"/>
                      </a:ext>
                    </a:extLst>
                  </p:cNvPr>
                  <p:cNvSpPr/>
                  <p:nvPr/>
                </p:nvSpPr>
                <p:spPr>
                  <a:xfrm>
                    <a:off x="-67817" y="5763811"/>
                    <a:ext cx="35779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fr-FR" sz="600" dirty="0">
                        <a:latin typeface="Arial"/>
                        <a:cs typeface="Arial"/>
                      </a:rPr>
                      <a:t>2000</a:t>
                    </a:r>
                  </a:p>
                </p:txBody>
              </p:sp>
              <p:pic>
                <p:nvPicPr>
                  <p:cNvPr id="300" name="Image 29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0CD7E0C-1546-E34E-ACC1-69B3F559F943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6"/>
                  <a:srcRect b="16162"/>
                  <a:stretch/>
                </p:blipFill>
                <p:spPr>
                  <a:xfrm>
                    <a:off x="308032" y="5355041"/>
                    <a:ext cx="1044000" cy="1260000"/>
                  </a:xfrm>
                  <a:prstGeom prst="rect">
                    <a:avLst/>
                  </a:prstGeom>
                </p:spPr>
              </p:pic>
              <p:sp>
                <p:nvSpPr>
                  <p:cNvPr id="397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17CE391-066C-564C-8DAE-BD2818EEEEF4}"/>
                      </a:ext>
                    </a:extLst>
                  </p:cNvPr>
                  <p:cNvSpPr txBox="1"/>
                  <p:nvPr/>
                </p:nvSpPr>
                <p:spPr>
                  <a:xfrm>
                    <a:off x="539947" y="5233858"/>
                    <a:ext cx="41782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g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398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DB6F5C6-0611-9B47-9D53-C423245A253D}"/>
                      </a:ext>
                    </a:extLst>
                  </p:cNvPr>
                  <p:cNvSpPr txBox="1"/>
                  <p:nvPr/>
                </p:nvSpPr>
                <p:spPr>
                  <a:xfrm>
                    <a:off x="507827" y="4811401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6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77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sp>
                <p:nvSpPr>
                  <p:cNvPr id="399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E580EA3-4B4D-B849-AAB3-E7E77ED27412}"/>
                      </a:ext>
                    </a:extLst>
                  </p:cNvPr>
                  <p:cNvSpPr txBox="1"/>
                  <p:nvPr/>
                </p:nvSpPr>
                <p:spPr>
                  <a:xfrm>
                    <a:off x="747893" y="5123424"/>
                    <a:ext cx="39193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00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E2CF195-C8A9-DC4F-A771-416CDBC590F5}"/>
                      </a:ext>
                    </a:extLst>
                  </p:cNvPr>
                  <p:cNvSpPr txBox="1"/>
                  <p:nvPr/>
                </p:nvSpPr>
                <p:spPr>
                  <a:xfrm>
                    <a:off x="1079864" y="5233858"/>
                    <a:ext cx="299285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RNA</a:t>
                    </a:r>
                  </a:p>
                </p:txBody>
              </p:sp>
              <p:sp>
                <p:nvSpPr>
                  <p:cNvPr id="401" name="Parenthèse ouvrante 40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B6D3930-C172-2A4E-97E6-EC263522B3C9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931347" y="4737337"/>
                    <a:ext cx="45719" cy="756000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453" name="Groupe 45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4B4C473-C8F5-8047-BB52-58FEC6020E43}"/>
                    </a:ext>
                  </a:extLst>
                </p:cNvPr>
                <p:cNvGrpSpPr/>
                <p:nvPr/>
              </p:nvGrpSpPr>
              <p:grpSpPr>
                <a:xfrm>
                  <a:off x="1319976" y="3534972"/>
                  <a:ext cx="1438312" cy="1804671"/>
                  <a:chOff x="1621052" y="4694360"/>
                  <a:chExt cx="1438312" cy="1804671"/>
                </a:xfrm>
              </p:grpSpPr>
              <p:grpSp>
                <p:nvGrpSpPr>
                  <p:cNvPr id="447" name="Groupe 44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0274529-560E-6C45-AF1C-BFE904A16558}"/>
                      </a:ext>
                    </a:extLst>
                  </p:cNvPr>
                  <p:cNvGrpSpPr/>
                  <p:nvPr/>
                </p:nvGrpSpPr>
                <p:grpSpPr>
                  <a:xfrm>
                    <a:off x="1621052" y="5720916"/>
                    <a:ext cx="405541" cy="733660"/>
                    <a:chOff x="1621052" y="5720916"/>
                    <a:chExt cx="405541" cy="733660"/>
                  </a:xfrm>
                </p:grpSpPr>
                <p:cxnSp>
                  <p:nvCxnSpPr>
                    <p:cNvPr id="433" name="Connecteur droit avec flèche 43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7158021-44B2-B14A-821B-A669505639F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918593" y="6372485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34" name="Rectangle 43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9D88FCE-F75F-4845-8F01-065CAA098E0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42692" y="6269910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435" name="Connecteur droit avec flèche 43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B050AA0-436A-574B-9DCB-A585E2524C2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918593" y="6245698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36" name="Rectangle 43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98C95F5-D9DD-8B4D-8991-A057D29D00E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42692" y="6140143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6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437" name="Connecteur droit avec flèche 43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B47AF1-2D46-BE41-BA7E-846FC3AA943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918593" y="6138349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38" name="Rectangle 43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4809DC1-CF01-BC41-8083-4CF8186070F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42692" y="6041798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8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439" name="Rectangle 43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6877520-3B61-F849-A46C-0A2EA29C38B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21052" y="5921256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0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440" name="Groupe 43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ACB7E6B-73CF-CE46-B9B6-38A23962E03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888682" y="6017376"/>
                      <a:ext cx="137911" cy="49020"/>
                      <a:chOff x="311886" y="3665448"/>
                      <a:chExt cx="137911" cy="49020"/>
                    </a:xfrm>
                  </p:grpSpPr>
                  <p:cxnSp>
                    <p:nvCxnSpPr>
                      <p:cNvPr id="441" name="Connecteur droit avec flèche 44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EE0554D-DD30-0340-AD2F-031157337C4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1129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42" name="Connecteur droit avec flèche 44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6FDE688-8D35-044F-96D9-1A3193D10A5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 flipV="1">
                        <a:off x="311886" y="3665448"/>
                        <a:ext cx="36000" cy="4902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443" name="Connecteur droit avec flèche 44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726B15A-E481-1D48-8BE1-A16A67404B0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918593" y="5902247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44" name="Rectangle 44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99EC801-BB5A-1D4B-8D38-696C6FBD83B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21052" y="5809914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5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445" name="Connecteur droit avec flèche 44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ECC86F0-2134-1240-B96A-CC6B1BF434E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918593" y="5818208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46" name="Rectangle 44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0DB4884-F718-4E40-9EED-690D2F83B17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21052" y="5720916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fr-FR" sz="600" dirty="0">
                          <a:latin typeface="Arial"/>
                          <a:cs typeface="Arial"/>
                        </a:rPr>
                        <a:t>2000</a:t>
                      </a:r>
                    </a:p>
                  </p:txBody>
                </p:sp>
              </p:grpSp>
              <p:pic>
                <p:nvPicPr>
                  <p:cNvPr id="403" name="Image 40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36CF673-6FF6-ED49-AE7A-875D01C21AB1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7"/>
                  <a:srcRect b="12304"/>
                  <a:stretch/>
                </p:blipFill>
                <p:spPr>
                  <a:xfrm>
                    <a:off x="1991329" y="5239031"/>
                    <a:ext cx="1044000" cy="1260000"/>
                  </a:xfrm>
                  <a:prstGeom prst="rect">
                    <a:avLst/>
                  </a:prstGeom>
                </p:spPr>
              </p:pic>
              <p:sp>
                <p:nvSpPr>
                  <p:cNvPr id="448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ED10313-33E6-C54C-B1FE-7735FDEFB9D6}"/>
                      </a:ext>
                    </a:extLst>
                  </p:cNvPr>
                  <p:cNvSpPr txBox="1"/>
                  <p:nvPr/>
                </p:nvSpPr>
                <p:spPr>
                  <a:xfrm>
                    <a:off x="2191964" y="5100643"/>
                    <a:ext cx="41782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g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49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480906-BACE-7A4D-9536-78E053D05657}"/>
                      </a:ext>
                    </a:extLst>
                  </p:cNvPr>
                  <p:cNvSpPr txBox="1"/>
                  <p:nvPr/>
                </p:nvSpPr>
                <p:spPr>
                  <a:xfrm>
                    <a:off x="2217649" y="4694360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7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365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sp>
                <p:nvSpPr>
                  <p:cNvPr id="450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0829FB3-6EB0-2941-A5B3-E6C45AF90618}"/>
                      </a:ext>
                    </a:extLst>
                  </p:cNvPr>
                  <p:cNvSpPr txBox="1"/>
                  <p:nvPr/>
                </p:nvSpPr>
                <p:spPr>
                  <a:xfrm>
                    <a:off x="2436485" y="4982893"/>
                    <a:ext cx="39193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51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1AD5344-7D0E-5241-AB84-9933C8FBA79D}"/>
                      </a:ext>
                    </a:extLst>
                  </p:cNvPr>
                  <p:cNvSpPr txBox="1"/>
                  <p:nvPr/>
                </p:nvSpPr>
                <p:spPr>
                  <a:xfrm>
                    <a:off x="2731881" y="5100643"/>
                    <a:ext cx="299285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RNA</a:t>
                    </a:r>
                  </a:p>
                </p:txBody>
              </p:sp>
              <p:sp>
                <p:nvSpPr>
                  <p:cNvPr id="452" name="Parenthèse ouvrante 45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B7B9119-4A59-F14A-820B-9E33597ED0F3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2619100" y="4598227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473" name="Groupe 47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FADA2A1-FE01-9546-8018-80EC06CD4D8B}"/>
                    </a:ext>
                  </a:extLst>
                </p:cNvPr>
                <p:cNvGrpSpPr/>
                <p:nvPr/>
              </p:nvGrpSpPr>
              <p:grpSpPr>
                <a:xfrm>
                  <a:off x="2641459" y="3534972"/>
                  <a:ext cx="1441113" cy="1803640"/>
                  <a:chOff x="3136187" y="4811401"/>
                  <a:chExt cx="1441113" cy="1803640"/>
                </a:xfrm>
              </p:grpSpPr>
              <p:cxnSp>
                <p:nvCxnSpPr>
                  <p:cNvPr id="454" name="Connecteur droit avec flèche 45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E96D467-200C-A042-9FB9-132E008568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433728" y="6410541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55" name="Rectangle 45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4525E79-200B-F241-BE33-8D1D3AD6FCCC}"/>
                      </a:ext>
                    </a:extLst>
                  </p:cNvPr>
                  <p:cNvSpPr/>
                  <p:nvPr/>
                </p:nvSpPr>
                <p:spPr>
                  <a:xfrm>
                    <a:off x="3157827" y="6307966"/>
                    <a:ext cx="31451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4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456" name="Connecteur droit avec flèche 45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877162C-D3CA-5B49-95EA-F0F07A54E3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433728" y="6298384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57" name="Rectangle 45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147DD7C-0DA2-894E-A395-34CD320541F3}"/>
                      </a:ext>
                    </a:extLst>
                  </p:cNvPr>
                  <p:cNvSpPr/>
                  <p:nvPr/>
                </p:nvSpPr>
                <p:spPr>
                  <a:xfrm>
                    <a:off x="3157827" y="6192829"/>
                    <a:ext cx="31451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6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458" name="Connecteur droit avec flèche 45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1763F68-C3A2-E24F-8DEC-7CA8F100D66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433728" y="6212983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59" name="Rectangle 45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93C454C-B147-D148-964F-6472044C5630}"/>
                      </a:ext>
                    </a:extLst>
                  </p:cNvPr>
                  <p:cNvSpPr/>
                  <p:nvPr/>
                </p:nvSpPr>
                <p:spPr>
                  <a:xfrm>
                    <a:off x="3157827" y="6116432"/>
                    <a:ext cx="31451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8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60" name="Rectangle 45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8618F24-1C73-6C43-8E75-9850CC192307}"/>
                      </a:ext>
                    </a:extLst>
                  </p:cNvPr>
                  <p:cNvSpPr/>
                  <p:nvPr/>
                </p:nvSpPr>
                <p:spPr>
                  <a:xfrm>
                    <a:off x="3136187" y="5995890"/>
                    <a:ext cx="35779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0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461" name="Groupe 46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3AAEB19-53BF-0A48-BC67-5FE6D323372D}"/>
                      </a:ext>
                    </a:extLst>
                  </p:cNvPr>
                  <p:cNvGrpSpPr/>
                  <p:nvPr/>
                </p:nvGrpSpPr>
                <p:grpSpPr>
                  <a:xfrm>
                    <a:off x="3403817" y="6092010"/>
                    <a:ext cx="137911" cy="49020"/>
                    <a:chOff x="311886" y="3665448"/>
                    <a:chExt cx="137911" cy="49020"/>
                  </a:xfrm>
                </p:grpSpPr>
                <p:cxnSp>
                  <p:nvCxnSpPr>
                    <p:cNvPr id="462" name="Connecteur droit avec flèche 46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F93C409-55C6-A948-833B-222CE1B16E7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41797" y="3711293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3" name="Connecteur droit avec flèche 46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ED93094-112D-C54D-A631-D481D92AA49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 flipV="1">
                      <a:off x="311886" y="3665448"/>
                      <a:ext cx="36000" cy="4902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464" name="Connecteur droit avec flèche 46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AF97192-F0F6-D146-A2AA-78858A56B49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433728" y="5984196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5" name="Rectangle 46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25450D7-F2F7-294B-B592-2E5F758295C5}"/>
                      </a:ext>
                    </a:extLst>
                  </p:cNvPr>
                  <p:cNvSpPr/>
                  <p:nvPr/>
                </p:nvSpPr>
                <p:spPr>
                  <a:xfrm>
                    <a:off x="3136187" y="5891863"/>
                    <a:ext cx="35779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500</a:t>
                    </a:r>
                    <a:endParaRPr lang="fr-FR" sz="6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466" name="Connecteur droit avec flèche 46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736C5D8-7DEF-5648-81BB-08C1D36E948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433728" y="5878210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7" name="Rectangle 46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F25885E-9CCD-174D-9312-F434A961B118}"/>
                      </a:ext>
                    </a:extLst>
                  </p:cNvPr>
                  <p:cNvSpPr/>
                  <p:nvPr/>
                </p:nvSpPr>
                <p:spPr>
                  <a:xfrm>
                    <a:off x="3136187" y="5780918"/>
                    <a:ext cx="357790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fr-FR" sz="600" dirty="0">
                        <a:latin typeface="Arial"/>
                        <a:cs typeface="Arial"/>
                      </a:rPr>
                      <a:t>2000</a:t>
                    </a:r>
                  </a:p>
                </p:txBody>
              </p:sp>
              <p:sp>
                <p:nvSpPr>
                  <p:cNvPr id="468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C119CE-78BD-5A47-B938-2DF60F089CB6}"/>
                      </a:ext>
                    </a:extLst>
                  </p:cNvPr>
                  <p:cNvSpPr txBox="1"/>
                  <p:nvPr/>
                </p:nvSpPr>
                <p:spPr>
                  <a:xfrm>
                    <a:off x="3709900" y="5233858"/>
                    <a:ext cx="41782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g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69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41BB87E-5C41-904D-96BE-A90C3EBCF597}"/>
                      </a:ext>
                    </a:extLst>
                  </p:cNvPr>
                  <p:cNvSpPr txBox="1"/>
                  <p:nvPr/>
                </p:nvSpPr>
                <p:spPr>
                  <a:xfrm>
                    <a:off x="3735585" y="4811401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8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394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sp>
                <p:nvSpPr>
                  <p:cNvPr id="470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3E8732F-CAEB-6442-9596-C21E96A5A14E}"/>
                      </a:ext>
                    </a:extLst>
                  </p:cNvPr>
                  <p:cNvSpPr txBox="1"/>
                  <p:nvPr/>
                </p:nvSpPr>
                <p:spPr>
                  <a:xfrm>
                    <a:off x="3917846" y="5123424"/>
                    <a:ext cx="39193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71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D42C74C-2ECA-B447-BFB4-27D76849679E}"/>
                      </a:ext>
                    </a:extLst>
                  </p:cNvPr>
                  <p:cNvSpPr txBox="1"/>
                  <p:nvPr/>
                </p:nvSpPr>
                <p:spPr>
                  <a:xfrm>
                    <a:off x="4249817" y="5233858"/>
                    <a:ext cx="299285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RNA</a:t>
                    </a:r>
                  </a:p>
                </p:txBody>
              </p:sp>
              <p:sp>
                <p:nvSpPr>
                  <p:cNvPr id="472" name="Parenthèse ouvrante 47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46F5013-CA28-184C-ABB7-910D34B65D6C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4137036" y="4715268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pic>
                <p:nvPicPr>
                  <p:cNvPr id="413" name="Image 41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5743A17-1748-3B41-BA80-67BDBA332B7A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8"/>
                  <a:srcRect b="9341"/>
                  <a:stretch/>
                </p:blipFill>
                <p:spPr>
                  <a:xfrm>
                    <a:off x="3503477" y="5355041"/>
                    <a:ext cx="1044000" cy="12600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494" name="Groupe 49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5FC269B-6D56-3C4B-BE81-A58F26253FA7}"/>
                    </a:ext>
                  </a:extLst>
                </p:cNvPr>
                <p:cNvGrpSpPr/>
                <p:nvPr/>
              </p:nvGrpSpPr>
              <p:grpSpPr>
                <a:xfrm>
                  <a:off x="4022873" y="3534972"/>
                  <a:ext cx="1417254" cy="1803640"/>
                  <a:chOff x="4456386" y="4811401"/>
                  <a:chExt cx="1417254" cy="1803640"/>
                </a:xfrm>
              </p:grpSpPr>
              <p:grpSp>
                <p:nvGrpSpPr>
                  <p:cNvPr id="493" name="Groupe 49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C1F94B5-346E-4E4A-8108-2718180630EB}"/>
                      </a:ext>
                    </a:extLst>
                  </p:cNvPr>
                  <p:cNvGrpSpPr/>
                  <p:nvPr/>
                </p:nvGrpSpPr>
                <p:grpSpPr>
                  <a:xfrm>
                    <a:off x="4456386" y="5828100"/>
                    <a:ext cx="417979" cy="769886"/>
                    <a:chOff x="4456386" y="5828100"/>
                    <a:chExt cx="417979" cy="769886"/>
                  </a:xfrm>
                </p:grpSpPr>
                <p:cxnSp>
                  <p:nvCxnSpPr>
                    <p:cNvPr id="474" name="Connecteur droit avec flèche 47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5116036-61E0-6349-A58B-6BAA264E04D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766365" y="6515895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75" name="Rectangle 47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D75FC44-D4A1-904B-B2EF-85B01C4623B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78026" y="6413320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476" name="Connecteur droit avec flèche 47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2D8CACD-9DEA-E948-81C3-4251E06AFDD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766365" y="6367476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77" name="Rectangle 47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E289E7C-74F2-C74B-A610-CAEB6EC4D7F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78026" y="6275143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6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478" name="Connecteur droit avec flèche 47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10EA600-C1BC-9843-B2AD-DC1FFEBCDF7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766365" y="6290171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79" name="Rectangle 47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1F4B0B2-FBEE-924D-8B0A-83472840B56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78026" y="6193620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8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480" name="Rectangle 47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F162DC5-C908-F340-9FF7-61F3C926743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56386" y="6086613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0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481" name="Groupe 48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5E823CE-479A-8B42-BC8D-08F358D72B0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736454" y="6182733"/>
                      <a:ext cx="137911" cy="49020"/>
                      <a:chOff x="311886" y="3665448"/>
                      <a:chExt cx="137911" cy="49020"/>
                    </a:xfrm>
                  </p:grpSpPr>
                  <p:cxnSp>
                    <p:nvCxnSpPr>
                      <p:cNvPr id="482" name="Connecteur droit avec flèche 48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6C9A2EA-6487-AF41-BC16-04E362994B6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1129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83" name="Connecteur droit avec flèche 48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9755BBC-CE8C-DF46-A5F5-ED83875B01F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 flipV="1">
                        <a:off x="311886" y="3665448"/>
                        <a:ext cx="36000" cy="4902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484" name="Connecteur droit avec flèche 48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6B04CBF-1360-5949-A558-DAB13D0176F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766365" y="6041629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85" name="Rectangle 48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85367BB-7EF8-6548-882A-EDAD289631E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56386" y="5949296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5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486" name="Connecteur droit avec flèche 48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B62023A-F080-1F40-A4EF-FD72DABC3AD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766365" y="5925392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87" name="Rectangle 48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F46EAC1-6C23-EF49-8B8E-184299837E0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56386" y="5828100"/>
                      <a:ext cx="35779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fr-FR" sz="600" dirty="0">
                          <a:latin typeface="Arial"/>
                          <a:cs typeface="Arial"/>
                        </a:rPr>
                        <a:t>2000</a:t>
                      </a:r>
                    </a:p>
                  </p:txBody>
                </p:sp>
              </p:grpSp>
              <p:pic>
                <p:nvPicPr>
                  <p:cNvPr id="423" name="Image 42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1DB065D-79D0-9F46-978A-B9C5CD5421DE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9"/>
                  <a:srcRect b="16368"/>
                  <a:stretch/>
                </p:blipFill>
                <p:spPr>
                  <a:xfrm>
                    <a:off x="4821908" y="5355041"/>
                    <a:ext cx="1044000" cy="1260000"/>
                  </a:xfrm>
                  <a:prstGeom prst="rect">
                    <a:avLst/>
                  </a:prstGeom>
                </p:spPr>
              </p:pic>
              <p:sp>
                <p:nvSpPr>
                  <p:cNvPr id="488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8BB2BFE-B2E4-D64E-9088-071C07D89E40}"/>
                      </a:ext>
                    </a:extLst>
                  </p:cNvPr>
                  <p:cNvSpPr txBox="1"/>
                  <p:nvPr/>
                </p:nvSpPr>
                <p:spPr>
                  <a:xfrm>
                    <a:off x="5006240" y="5233858"/>
                    <a:ext cx="41782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g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89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0039F85-874F-3A46-A257-8CE1D2F75453}"/>
                      </a:ext>
                    </a:extLst>
                  </p:cNvPr>
                  <p:cNvSpPr txBox="1"/>
                  <p:nvPr/>
                </p:nvSpPr>
                <p:spPr>
                  <a:xfrm>
                    <a:off x="5031925" y="4811401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9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394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sp>
                <p:nvSpPr>
                  <p:cNvPr id="490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A5C0ED0-4CFB-CA4F-93A8-0673EF629A98}"/>
                      </a:ext>
                    </a:extLst>
                  </p:cNvPr>
                  <p:cNvSpPr txBox="1"/>
                  <p:nvPr/>
                </p:nvSpPr>
                <p:spPr>
                  <a:xfrm>
                    <a:off x="5214186" y="5123424"/>
                    <a:ext cx="39193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91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0E07BC0-4D46-7545-AA8B-DC5F32D7771D}"/>
                      </a:ext>
                    </a:extLst>
                  </p:cNvPr>
                  <p:cNvSpPr txBox="1"/>
                  <p:nvPr/>
                </p:nvSpPr>
                <p:spPr>
                  <a:xfrm>
                    <a:off x="5546157" y="5233858"/>
                    <a:ext cx="299285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RNA</a:t>
                    </a:r>
                  </a:p>
                </p:txBody>
              </p:sp>
              <p:sp>
                <p:nvSpPr>
                  <p:cNvPr id="492" name="Parenthèse ouvrante 49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665947B-DFBA-AA42-B6D9-BEB094BBCEFF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5433376" y="4715268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498" name="Groupe 497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9859C81-11FE-E745-8ED8-FF392B1D242E}"/>
                    </a:ext>
                  </a:extLst>
                </p:cNvPr>
                <p:cNvGrpSpPr/>
                <p:nvPr/>
              </p:nvGrpSpPr>
              <p:grpSpPr>
                <a:xfrm>
                  <a:off x="-46564" y="1599123"/>
                  <a:ext cx="1455004" cy="1841471"/>
                  <a:chOff x="190103" y="2763012"/>
                  <a:chExt cx="1455004" cy="1841471"/>
                </a:xfrm>
              </p:grpSpPr>
              <p:sp>
                <p:nvSpPr>
                  <p:cNvPr id="227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0349B82-4CB1-0B45-90D2-292CDF75E125}"/>
                      </a:ext>
                    </a:extLst>
                  </p:cNvPr>
                  <p:cNvSpPr txBox="1"/>
                  <p:nvPr/>
                </p:nvSpPr>
                <p:spPr>
                  <a:xfrm>
                    <a:off x="1006536" y="3102144"/>
                    <a:ext cx="39193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497" name="Groupe 49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E712830-5010-E24A-8898-FDD393138E19}"/>
                      </a:ext>
                    </a:extLst>
                  </p:cNvPr>
                  <p:cNvGrpSpPr/>
                  <p:nvPr/>
                </p:nvGrpSpPr>
                <p:grpSpPr>
                  <a:xfrm>
                    <a:off x="190103" y="2763012"/>
                    <a:ext cx="1455004" cy="1841471"/>
                    <a:chOff x="190103" y="2763012"/>
                    <a:chExt cx="1455004" cy="1841471"/>
                  </a:xfrm>
                </p:grpSpPr>
                <p:sp>
                  <p:nvSpPr>
                    <p:cNvPr id="225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D397B16-8D4D-0144-84CF-1E7F2F8733D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47385" y="3212578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26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E6811D2-D372-794E-9C04-B2051D8D235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3070" y="2763012"/>
                      <a:ext cx="84171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(215 </a:t>
                      </a:r>
                      <a:r>
                        <a:rPr lang="en-US" sz="9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bp</a:t>
                      </a: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)</a:t>
                      </a:r>
                    </a:p>
                  </p:txBody>
                </p:sp>
                <p:sp>
                  <p:nvSpPr>
                    <p:cNvPr id="228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0F02AAE-EC9E-9443-A3CA-E4AB16C2718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45822" y="3212578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  <p:sp>
                  <p:nvSpPr>
                    <p:cNvPr id="229" name="Parenthèse ouvrante 22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C96444C-BE32-BF42-8535-2E7927CDC2D7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1174521" y="2673912"/>
                      <a:ext cx="45719" cy="800138"/>
                    </a:xfrm>
                    <a:prstGeom prst="leftBracket">
                      <a:avLst/>
                    </a:prstGeom>
                    <a:ln w="1905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496" name="Groupe 49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E21740E-322B-0445-B000-7AEA530A6B4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90103" y="3875273"/>
                      <a:ext cx="411543" cy="716159"/>
                      <a:chOff x="190103" y="3875273"/>
                      <a:chExt cx="411543" cy="716159"/>
                    </a:xfrm>
                  </p:grpSpPr>
                  <p:cxnSp>
                    <p:nvCxnSpPr>
                      <p:cNvPr id="86" name="Connecteur droit avec flèche 8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C18771F-35E3-664E-AB0D-4345B4207AD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493646" y="4371490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4" name="Rectangle 9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73C1BF-121E-2248-92A7-A5AD02FAD44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11743" y="4268915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4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cxnSp>
                    <p:nvCxnSpPr>
                      <p:cNvPr id="84" name="Connecteur droit avec flèche 8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FB06D35-CD4A-174C-96AE-99F70D4F2F1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493646" y="428596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5" name="Rectangle 9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82545AF-F3B3-964F-95D3-07CCC6C9E47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11743" y="4180408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cxnSp>
                    <p:nvCxnSpPr>
                      <p:cNvPr id="87" name="Connecteur droit avec flèche 8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7E62717-69F5-2741-AA90-0C8000D880F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493646" y="4181725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6" name="Rectangle 9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B729508-A379-9E4F-B47A-1BDA2AC3DF8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11743" y="4085174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8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sp>
                    <p:nvSpPr>
                      <p:cNvPr id="97" name="Rectangle 9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1A10FD5-51EA-D741-9209-43111B37434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90103" y="3978781"/>
                        <a:ext cx="35779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0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grpSp>
                    <p:nvGrpSpPr>
                      <p:cNvPr id="106" name="Groupe 10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0EC03EF-A2A4-FD4F-A03F-EA8D841BDDC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63735" y="4074901"/>
                        <a:ext cx="137911" cy="49020"/>
                        <a:chOff x="311886" y="3665448"/>
                        <a:chExt cx="137911" cy="49020"/>
                      </a:xfrm>
                    </p:grpSpPr>
                    <p:cxnSp>
                      <p:nvCxnSpPr>
                        <p:cNvPr id="88" name="Connecteur droit avec flèche 8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02FCE7C-2BA0-5D44-A50F-63B8C15D6AC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341797" y="371129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98" name="Connecteur droit avec flèche 9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40D480A-8B57-1249-921F-A2D1605FCFF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311886" y="3665448"/>
                          <a:ext cx="36000" cy="4902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89" name="Connecteur droit avec flèche 8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182CF50-2AAC-0C44-8F96-7C53A9169A7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493646" y="3994510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0" name="Rectangle 9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8A6EFF0-1F32-6A4D-B22F-C0030D20413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90103" y="3875273"/>
                        <a:ext cx="35779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5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cxnSp>
                    <p:nvCxnSpPr>
                      <p:cNvPr id="243" name="Connecteur droit avec flèche 24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A480118-F576-3747-BBC0-FA5303734FE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493646" y="4502617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44" name="Rectangle 24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BCAE9A1-7866-D342-A9EA-361B18B57F2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11743" y="4406766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2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pic>
                  <p:nvPicPr>
                    <p:cNvPr id="224" name="Image 223" descr="D:\Articles Samuel\Gel\GelDocXRPlus 2019-01-09 12hr 17min.jpg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1A54A8D-8B65-C448-BBF4-056178C11BB2}"/>
                        </a:ext>
                      </a:extLst>
                    </p:cNvPr>
                    <p:cNvPicPr preferRelativeResize="0">
                      <a:picLocks noChangeAspect="1"/>
                    </p:cNvPicPr>
                    <p:nvPr/>
                  </p:nvPicPr>
                  <p:blipFill rotWithShape="1">
                    <a:blip r:embed="rId10">
                      <a:extLst>
                        <a:ext uri="{28A0092B-C50C-407E-A947-70E740481C1C}">
    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    </a:ext>
                      </a:extLst>
                    </a:blip>
                    <a:srcRect l="64905" t="26004" r="18525" b="47264"/>
                    <a:stretch/>
                  </p:blipFill>
                  <p:spPr bwMode="auto">
                    <a:xfrm>
                      <a:off x="553892" y="3344483"/>
                      <a:ext cx="1043558" cy="1260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53640926-AAD7-44d8-BBD7-CCE9431645EC}">
                        <a14:shadowObscured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="" xmlns:mv="urn:schemas-microsoft-com:mac:vml" xmlns:mc="http://schemas.openxmlformats.org/markup-compatibility/2006"/>
                      </a:ext>
                    </a:extLst>
                  </p:spPr>
                </p:pic>
              </p:grpSp>
            </p:grpSp>
          </p:grpSp>
          <p:sp>
            <p:nvSpPr>
              <p:cNvPr id="404" name="ZoneTexte 403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10ACF30-58B7-5C46-95B7-4436EE06EF52}"/>
                  </a:ext>
                </a:extLst>
              </p:cNvPr>
              <p:cNvSpPr txBox="1"/>
              <p:nvPr/>
            </p:nvSpPr>
            <p:spPr>
              <a:xfrm>
                <a:off x="-29902" y="1507025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dirty="0">
                    <a:latin typeface="Arial"/>
                    <a:cs typeface="Arial"/>
                  </a:rPr>
                  <a:t>B</a:t>
                </a:r>
              </a:p>
            </p:txBody>
          </p:sp>
        </p:grpSp>
        <p:grpSp>
          <p:nvGrpSpPr>
            <p:cNvPr id="27" name="Groupe 26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DF786B4-FA1A-CA44-8D80-3F4D178B4C51}"/>
                </a:ext>
              </a:extLst>
            </p:cNvPr>
            <p:cNvGrpSpPr/>
            <p:nvPr/>
          </p:nvGrpSpPr>
          <p:grpSpPr>
            <a:xfrm>
              <a:off x="-29902" y="5322523"/>
              <a:ext cx="6571260" cy="3439291"/>
              <a:chOff x="-29902" y="5551131"/>
              <a:chExt cx="6571260" cy="3439291"/>
            </a:xfrm>
          </p:grpSpPr>
          <p:sp>
            <p:nvSpPr>
              <p:cNvPr id="405" name="ZoneTexte 404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D19CA7B-E574-3048-AC82-B0889D24FEBF}"/>
                  </a:ext>
                </a:extLst>
              </p:cNvPr>
              <p:cNvSpPr txBox="1"/>
              <p:nvPr/>
            </p:nvSpPr>
            <p:spPr>
              <a:xfrm>
                <a:off x="-29902" y="5581969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grpSp>
            <p:nvGrpSpPr>
              <p:cNvPr id="23" name="Groupe 22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105FE9D-495E-174E-9A59-9B89FEB5B79E}"/>
                  </a:ext>
                </a:extLst>
              </p:cNvPr>
              <p:cNvGrpSpPr/>
              <p:nvPr/>
            </p:nvGrpSpPr>
            <p:grpSpPr>
              <a:xfrm>
                <a:off x="324884" y="5551131"/>
                <a:ext cx="6216474" cy="3439291"/>
                <a:chOff x="324884" y="5551131"/>
                <a:chExt cx="6216474" cy="3439291"/>
              </a:xfrm>
            </p:grpSpPr>
            <p:sp>
              <p:nvSpPr>
                <p:cNvPr id="510" name="ZoneTexte 50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ADA1B07-2094-124A-811E-5A02889C9AE7}"/>
                    </a:ext>
                  </a:extLst>
                </p:cNvPr>
                <p:cNvSpPr txBox="1"/>
                <p:nvPr/>
              </p:nvSpPr>
              <p:spPr>
                <a:xfrm rot="16200000">
                  <a:off x="-411428" y="6794921"/>
                  <a:ext cx="174962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200" b="1" dirty="0">
                      <a:latin typeface="Arial"/>
                      <a:cs typeface="Arial"/>
                    </a:rPr>
                    <a:t>Gene expression </a:t>
                  </a:r>
                  <a:r>
                    <a:rPr lang="fr-FR" sz="1200" b="1" dirty="0" err="1">
                      <a:latin typeface="Arial"/>
                      <a:cs typeface="Arial"/>
                    </a:rPr>
                    <a:t>fold</a:t>
                  </a:r>
                  <a:endParaRPr lang="fr-FR" sz="12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36" name="ZoneTexte 53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6F39871-9B69-D04E-B1B7-59CD757DE997}"/>
                    </a:ext>
                  </a:extLst>
                </p:cNvPr>
                <p:cNvSpPr txBox="1"/>
                <p:nvPr/>
              </p:nvSpPr>
              <p:spPr>
                <a:xfrm>
                  <a:off x="5664195" y="8172827"/>
                  <a:ext cx="87716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000" b="1" dirty="0">
                      <a:latin typeface="Arial"/>
                      <a:cs typeface="Arial"/>
                    </a:rPr>
                    <a:t>10 </a:t>
                  </a:r>
                  <a:r>
                    <a:rPr lang="fr-FR" sz="1000" b="1" dirty="0" err="1">
                      <a:latin typeface="Arial"/>
                      <a:cs typeface="Arial"/>
                    </a:rPr>
                    <a:t>μM</a:t>
                  </a:r>
                  <a:r>
                    <a:rPr lang="fr-FR" sz="1000" b="1" dirty="0">
                      <a:latin typeface="Arial"/>
                      <a:cs typeface="Arial"/>
                    </a:rPr>
                    <a:t> H</a:t>
                  </a:r>
                  <a:r>
                    <a:rPr lang="fr-FR" sz="1000" b="1" baseline="-25000" dirty="0">
                      <a:latin typeface="Arial"/>
                      <a:cs typeface="Arial"/>
                    </a:rPr>
                    <a:t>2</a:t>
                  </a:r>
                  <a:r>
                    <a:rPr lang="fr-FR" sz="1000" b="1" dirty="0">
                      <a:latin typeface="Arial"/>
                      <a:cs typeface="Arial"/>
                    </a:rPr>
                    <a:t>O</a:t>
                  </a:r>
                  <a:r>
                    <a:rPr lang="fr-FR" sz="1000" b="1" baseline="-25000" dirty="0">
                      <a:latin typeface="Arial"/>
                      <a:cs typeface="Arial"/>
                    </a:rPr>
                    <a:t>2</a:t>
                  </a:r>
                </a:p>
              </p:txBody>
            </p:sp>
            <p:pic>
              <p:nvPicPr>
                <p:cNvPr id="3" name="Image 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72AC55F-A793-9B4D-8FB2-8E21D602E53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581389" y="5551131"/>
                  <a:ext cx="5227256" cy="2702591"/>
                </a:xfrm>
                <a:prstGeom prst="rect">
                  <a:avLst/>
                </a:prstGeom>
              </p:spPr>
            </p:pic>
            <p:grpSp>
              <p:nvGrpSpPr>
                <p:cNvPr id="15" name="Groupe 1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6D46ED4-4D80-1F4B-B296-03C53371E2B1}"/>
                    </a:ext>
                  </a:extLst>
                </p:cNvPr>
                <p:cNvGrpSpPr/>
                <p:nvPr/>
              </p:nvGrpSpPr>
              <p:grpSpPr>
                <a:xfrm>
                  <a:off x="839228" y="8159979"/>
                  <a:ext cx="607859" cy="830443"/>
                  <a:chOff x="839228" y="8159979"/>
                  <a:chExt cx="607859" cy="830443"/>
                </a:xfrm>
              </p:grpSpPr>
              <p:sp>
                <p:nvSpPr>
                  <p:cNvPr id="501" name="ZoneTexte 50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11A4DA-35E7-EC4D-BCE1-4A4988A20D10}"/>
                      </a:ext>
                    </a:extLst>
                  </p:cNvPr>
                  <p:cNvSpPr txBox="1"/>
                  <p:nvPr/>
                </p:nvSpPr>
                <p:spPr>
                  <a:xfrm>
                    <a:off x="839228" y="8436424"/>
                    <a:ext cx="607859" cy="5539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_17840</a:t>
                    </a:r>
                  </a:p>
                  <a:p>
                    <a:pPr algn="ctr"/>
                    <a:r>
                      <a:rPr lang="fr-FR" sz="1000" b="1" i="1" dirty="0" err="1">
                        <a:latin typeface="Arial"/>
                        <a:cs typeface="Arial"/>
                      </a:rPr>
                      <a:t>hemA</a:t>
                    </a:r>
                    <a:endParaRPr lang="fr-FR" sz="1000" b="1" i="1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2" name="Groupe 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1E12632-5D6E-8A4F-AE56-C78A56E61847}"/>
                      </a:ext>
                    </a:extLst>
                  </p:cNvPr>
                  <p:cNvGrpSpPr/>
                  <p:nvPr/>
                </p:nvGrpSpPr>
                <p:grpSpPr>
                  <a:xfrm>
                    <a:off x="852826" y="8159979"/>
                    <a:ext cx="592775" cy="307777"/>
                    <a:chOff x="856284" y="8159979"/>
                    <a:chExt cx="592775" cy="307777"/>
                  </a:xfrm>
                </p:grpSpPr>
                <p:sp>
                  <p:nvSpPr>
                    <p:cNvPr id="512" name="ZoneTexte 51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5D0C607-2527-EC44-AA2B-2CD375F4962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56284" y="8159979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-</a:t>
                      </a:r>
                    </a:p>
                  </p:txBody>
                </p:sp>
                <p:sp>
                  <p:nvSpPr>
                    <p:cNvPr id="513" name="ZoneTexte 51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368BC22-FDFE-1B47-A54A-23BA220692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85564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  <p:sp>
                  <p:nvSpPr>
                    <p:cNvPr id="524" name="ZoneTexte 52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D5353D0-3F63-6742-ACF1-94F0CB12E7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59547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306" name="Parenthèse ouvrante 30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4401A63-4815-AC4C-A0B2-046BCED473D5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1092887" y="8075297"/>
                    <a:ext cx="88428" cy="567484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16" name="Groupe 1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7E0C13F-F56F-CD41-8054-6F2987DF77D4}"/>
                    </a:ext>
                  </a:extLst>
                </p:cNvPr>
                <p:cNvGrpSpPr/>
                <p:nvPr/>
              </p:nvGrpSpPr>
              <p:grpSpPr>
                <a:xfrm>
                  <a:off x="1437097" y="8159979"/>
                  <a:ext cx="668774" cy="830443"/>
                  <a:chOff x="1437097" y="8159979"/>
                  <a:chExt cx="668774" cy="830443"/>
                </a:xfrm>
              </p:grpSpPr>
              <p:sp>
                <p:nvSpPr>
                  <p:cNvPr id="502" name="ZoneTexte 50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98D445F-DA16-7D49-8006-CF522178B954}"/>
                      </a:ext>
                    </a:extLst>
                  </p:cNvPr>
                  <p:cNvSpPr txBox="1"/>
                  <p:nvPr/>
                </p:nvSpPr>
                <p:spPr>
                  <a:xfrm>
                    <a:off x="1437097" y="8436424"/>
                    <a:ext cx="668774" cy="5539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_17845</a:t>
                    </a:r>
                  </a:p>
                  <a:p>
                    <a:pPr algn="ctr"/>
                    <a:r>
                      <a:rPr lang="fr-FR" sz="1000" b="1" i="1" dirty="0" err="1">
                        <a:latin typeface="Arial"/>
                        <a:cs typeface="Arial"/>
                      </a:rPr>
                      <a:t>hemC</a:t>
                    </a:r>
                    <a:r>
                      <a:rPr lang="fr-FR" sz="1000" b="1" i="1" dirty="0">
                        <a:latin typeface="Arial"/>
                        <a:cs typeface="Arial"/>
                      </a:rPr>
                      <a:t>/D</a:t>
                    </a:r>
                  </a:p>
                </p:txBody>
              </p:sp>
              <p:grpSp>
                <p:nvGrpSpPr>
                  <p:cNvPr id="5" name="Groupe 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37BEE12-FBC7-8643-A63C-3EBB3C449F0F}"/>
                      </a:ext>
                    </a:extLst>
                  </p:cNvPr>
                  <p:cNvGrpSpPr/>
                  <p:nvPr/>
                </p:nvGrpSpPr>
                <p:grpSpPr>
                  <a:xfrm>
                    <a:off x="1469299" y="8159979"/>
                    <a:ext cx="604371" cy="307777"/>
                    <a:chOff x="1471751" y="8159979"/>
                    <a:chExt cx="604371" cy="307777"/>
                  </a:xfrm>
                </p:grpSpPr>
                <p:sp>
                  <p:nvSpPr>
                    <p:cNvPr id="514" name="ZoneTexte 51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D87E41F-685C-6C40-921D-F9E18DB3C8E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71751" y="8159979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-</a:t>
                      </a:r>
                    </a:p>
                  </p:txBody>
                </p:sp>
                <p:sp>
                  <p:nvSpPr>
                    <p:cNvPr id="515" name="ZoneTexte 51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9155DBE-66B8-9748-A528-9A72DEE4F14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23331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  <p:sp>
                  <p:nvSpPr>
                    <p:cNvPr id="525" name="ZoneTexte 52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07CAD72-DE47-9E4D-BA76-71F3B6E0309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6610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308" name="Parenthèse ouvrante 30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5D98F6B-4A9A-E74D-8DBF-43C18CAE26E1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1727270" y="8075297"/>
                    <a:ext cx="88428" cy="567484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17" name="Groupe 16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3083EC-243A-C444-B2E6-ACDE1B136746}"/>
                    </a:ext>
                  </a:extLst>
                </p:cNvPr>
                <p:cNvGrpSpPr/>
                <p:nvPr/>
              </p:nvGrpSpPr>
              <p:grpSpPr>
                <a:xfrm>
                  <a:off x="2078445" y="8159979"/>
                  <a:ext cx="607859" cy="830443"/>
                  <a:chOff x="2078445" y="8159979"/>
                  <a:chExt cx="607859" cy="830443"/>
                </a:xfrm>
              </p:grpSpPr>
              <p:sp>
                <p:nvSpPr>
                  <p:cNvPr id="503" name="ZoneTexte 50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4ADFBD7-03FE-A946-810F-16BB09B276BD}"/>
                      </a:ext>
                    </a:extLst>
                  </p:cNvPr>
                  <p:cNvSpPr txBox="1"/>
                  <p:nvPr/>
                </p:nvSpPr>
                <p:spPr>
                  <a:xfrm>
                    <a:off x="2078445" y="8436424"/>
                    <a:ext cx="607859" cy="5539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_17850</a:t>
                    </a:r>
                  </a:p>
                  <a:p>
                    <a:pPr algn="ctr"/>
                    <a:r>
                      <a:rPr lang="fr-FR" sz="1000" b="1" i="1" dirty="0" err="1">
                        <a:latin typeface="Arial"/>
                        <a:cs typeface="Arial"/>
                      </a:rPr>
                      <a:t>hemB</a:t>
                    </a:r>
                    <a:endParaRPr lang="fr-FR" sz="1000" b="1" i="1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8" name="Groupe 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6895F01-2DCD-4143-8D5E-E4F26D770D91}"/>
                      </a:ext>
                    </a:extLst>
                  </p:cNvPr>
                  <p:cNvGrpSpPr/>
                  <p:nvPr/>
                </p:nvGrpSpPr>
                <p:grpSpPr>
                  <a:xfrm>
                    <a:off x="2080857" y="8159979"/>
                    <a:ext cx="603034" cy="307777"/>
                    <a:chOff x="2084942" y="8159979"/>
                    <a:chExt cx="603034" cy="307777"/>
                  </a:xfrm>
                </p:grpSpPr>
                <p:sp>
                  <p:nvSpPr>
                    <p:cNvPr id="516" name="ZoneTexte 51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67FE368-9345-8D4F-93EC-4B4933013EE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84942" y="8159979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-</a:t>
                      </a:r>
                    </a:p>
                  </p:txBody>
                </p:sp>
                <p:sp>
                  <p:nvSpPr>
                    <p:cNvPr id="517" name="ZoneTexte 51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3832F8A-CCDB-EB48-B07E-F7DDE9AB149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38270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  <p:sp>
                  <p:nvSpPr>
                    <p:cNvPr id="526" name="ZoneTexte 5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914C051-D689-2A42-9AA1-A52E1ADBE07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8464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311" name="Parenthèse ouvrante 31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D5AE88B-EF28-074C-8373-2C4A9B6D65CE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2338160" y="8075297"/>
                    <a:ext cx="88428" cy="567484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18" name="Groupe 17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5AEE33A-5A07-EA48-B98B-D4AE1A40F565}"/>
                    </a:ext>
                  </a:extLst>
                </p:cNvPr>
                <p:cNvGrpSpPr/>
                <p:nvPr/>
              </p:nvGrpSpPr>
              <p:grpSpPr>
                <a:xfrm>
                  <a:off x="2698484" y="8159979"/>
                  <a:ext cx="616309" cy="830443"/>
                  <a:chOff x="2698484" y="8159979"/>
                  <a:chExt cx="616309" cy="830443"/>
                </a:xfrm>
              </p:grpSpPr>
              <p:sp>
                <p:nvSpPr>
                  <p:cNvPr id="504" name="ZoneTexte 50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1AA85A6-3FC5-0C49-9F25-4A77ED03A641}"/>
                      </a:ext>
                    </a:extLst>
                  </p:cNvPr>
                  <p:cNvSpPr txBox="1"/>
                  <p:nvPr/>
                </p:nvSpPr>
                <p:spPr>
                  <a:xfrm>
                    <a:off x="2706934" y="8436424"/>
                    <a:ext cx="607859" cy="5539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_17855</a:t>
                    </a:r>
                  </a:p>
                  <a:p>
                    <a:pPr algn="ctr"/>
                    <a:r>
                      <a:rPr lang="fr-FR" sz="1000" b="1" i="1" dirty="0" err="1">
                        <a:latin typeface="Arial"/>
                        <a:cs typeface="Arial"/>
                      </a:rPr>
                      <a:t>hemL</a:t>
                    </a:r>
                    <a:endParaRPr lang="fr-FR" sz="1000" b="1" i="1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10" name="Groupe 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B783619-2785-D349-B37A-AC2C4168E014}"/>
                      </a:ext>
                    </a:extLst>
                  </p:cNvPr>
                  <p:cNvGrpSpPr/>
                  <p:nvPr/>
                </p:nvGrpSpPr>
                <p:grpSpPr>
                  <a:xfrm>
                    <a:off x="2698484" y="8159979"/>
                    <a:ext cx="612646" cy="307777"/>
                    <a:chOff x="2692428" y="8159979"/>
                    <a:chExt cx="612646" cy="307777"/>
                  </a:xfrm>
                </p:grpSpPr>
                <p:sp>
                  <p:nvSpPr>
                    <p:cNvPr id="518" name="ZoneTexte 51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9A0EA7E-CE16-0846-8AB0-BEB788FCD4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92428" y="8159979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-</a:t>
                      </a:r>
                    </a:p>
                  </p:txBody>
                </p:sp>
                <p:sp>
                  <p:nvSpPr>
                    <p:cNvPr id="519" name="ZoneTexte 51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E6315AA-E78E-A742-8A7E-34CDF0E14A9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843733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  <p:sp>
                  <p:nvSpPr>
                    <p:cNvPr id="527" name="ZoneTexte 52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523B2E0-D233-9F42-AA58-7EE44CBAC76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15562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314" name="Parenthèse ouvrante 31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D6C103B-54CD-294A-9E44-802E8F388C7E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2948481" y="8075297"/>
                    <a:ext cx="88428" cy="567484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19" name="Groupe 18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F5CEAF2-054B-2544-A438-7D9724F383CF}"/>
                    </a:ext>
                  </a:extLst>
                </p:cNvPr>
                <p:cNvGrpSpPr/>
                <p:nvPr/>
              </p:nvGrpSpPr>
              <p:grpSpPr>
                <a:xfrm>
                  <a:off x="3295717" y="8159979"/>
                  <a:ext cx="630839" cy="830443"/>
                  <a:chOff x="3295717" y="8159979"/>
                  <a:chExt cx="630839" cy="830443"/>
                </a:xfrm>
              </p:grpSpPr>
              <p:sp>
                <p:nvSpPr>
                  <p:cNvPr id="505" name="ZoneTexte 5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6F1035-4683-7E44-8BEA-FB520A11B15E}"/>
                      </a:ext>
                    </a:extLst>
                  </p:cNvPr>
                  <p:cNvSpPr txBox="1"/>
                  <p:nvPr/>
                </p:nvSpPr>
                <p:spPr>
                  <a:xfrm>
                    <a:off x="3307207" y="8436424"/>
                    <a:ext cx="607859" cy="5539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_17860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HK</a:t>
                    </a:r>
                  </a:p>
                </p:txBody>
              </p:sp>
              <p:grpSp>
                <p:nvGrpSpPr>
                  <p:cNvPr id="11" name="Groupe 1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630C9CA-A158-2C40-B1AF-3E5FED180ED9}"/>
                      </a:ext>
                    </a:extLst>
                  </p:cNvPr>
                  <p:cNvGrpSpPr/>
                  <p:nvPr/>
                </p:nvGrpSpPr>
                <p:grpSpPr>
                  <a:xfrm>
                    <a:off x="3295717" y="8159979"/>
                    <a:ext cx="630839" cy="307777"/>
                    <a:chOff x="3295717" y="8159979"/>
                    <a:chExt cx="630839" cy="307777"/>
                  </a:xfrm>
                </p:grpSpPr>
                <p:sp>
                  <p:nvSpPr>
                    <p:cNvPr id="520" name="ZoneTexte 51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1F1A31D-C145-6044-976E-5C0E59A9BB2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95717" y="8159979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-</a:t>
                      </a:r>
                    </a:p>
                  </p:txBody>
                </p:sp>
                <p:sp>
                  <p:nvSpPr>
                    <p:cNvPr id="521" name="ZoneTexte 52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E447713-9FCF-0041-A359-846E982EC32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62068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  <p:sp>
                  <p:nvSpPr>
                    <p:cNvPr id="528" name="ZoneTexte 52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27C92E3-6EB4-7A45-B692-A34CC13E37C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37044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317" name="Parenthèse ouvrante 31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0CC754-017E-B641-B75F-B5351F644A06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566922" y="8075297"/>
                    <a:ext cx="88428" cy="567484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20" name="Groupe 1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7108C9E-1ECE-C347-B1C7-85D2A9B3B5C6}"/>
                    </a:ext>
                  </a:extLst>
                </p:cNvPr>
                <p:cNvGrpSpPr/>
                <p:nvPr/>
              </p:nvGrpSpPr>
              <p:grpSpPr>
                <a:xfrm>
                  <a:off x="3923121" y="8159979"/>
                  <a:ext cx="610960" cy="830443"/>
                  <a:chOff x="3923121" y="8159979"/>
                  <a:chExt cx="610960" cy="830443"/>
                </a:xfrm>
              </p:grpSpPr>
              <p:sp>
                <p:nvSpPr>
                  <p:cNvPr id="506" name="ZoneTexte 50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5AFF4EF-4875-CC40-B70B-ECDD1B0246BE}"/>
                      </a:ext>
                    </a:extLst>
                  </p:cNvPr>
                  <p:cNvSpPr txBox="1"/>
                  <p:nvPr/>
                </p:nvSpPr>
                <p:spPr>
                  <a:xfrm>
                    <a:off x="3926222" y="8436424"/>
                    <a:ext cx="607859" cy="5539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_17865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RR</a:t>
                    </a:r>
                  </a:p>
                </p:txBody>
              </p:sp>
              <p:grpSp>
                <p:nvGrpSpPr>
                  <p:cNvPr id="12" name="Groupe 1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B3158B4-E09F-334F-9739-4FAEED671EB9}"/>
                      </a:ext>
                    </a:extLst>
                  </p:cNvPr>
                  <p:cNvGrpSpPr/>
                  <p:nvPr/>
                </p:nvGrpSpPr>
                <p:grpSpPr>
                  <a:xfrm>
                    <a:off x="3923121" y="8159979"/>
                    <a:ext cx="608005" cy="307777"/>
                    <a:chOff x="3937735" y="8159979"/>
                    <a:chExt cx="608005" cy="307777"/>
                  </a:xfrm>
                </p:grpSpPr>
                <p:sp>
                  <p:nvSpPr>
                    <p:cNvPr id="522" name="ZoneTexte 52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D680F59-51A0-A248-81E4-368FE355784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37735" y="8159979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-</a:t>
                      </a:r>
                    </a:p>
                  </p:txBody>
                </p:sp>
                <p:sp>
                  <p:nvSpPr>
                    <p:cNvPr id="523" name="ZoneTexte 52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A052B50-F5A2-8F41-83ED-0B4A3B61054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81252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  <p:sp>
                  <p:nvSpPr>
                    <p:cNvPr id="529" name="ZoneTexte 52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F6CD016-2405-3949-88A1-30430EC99FA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56228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322" name="Parenthèse ouvrante 32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FCE1FBD-C96B-A04B-AC8E-4FD5E7F2EEE0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173825" y="8075297"/>
                    <a:ext cx="88428" cy="567484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21" name="Groupe 20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9B95FA9-1414-7442-B8AF-B04E76962B78}"/>
                    </a:ext>
                  </a:extLst>
                </p:cNvPr>
                <p:cNvGrpSpPr/>
                <p:nvPr/>
              </p:nvGrpSpPr>
              <p:grpSpPr>
                <a:xfrm>
                  <a:off x="4532603" y="8159979"/>
                  <a:ext cx="613363" cy="830443"/>
                  <a:chOff x="4532603" y="8159979"/>
                  <a:chExt cx="613363" cy="830443"/>
                </a:xfrm>
              </p:grpSpPr>
              <p:sp>
                <p:nvSpPr>
                  <p:cNvPr id="507" name="ZoneTexte 50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42DFCA3-948C-C24D-9C41-E515DBBF75C2}"/>
                      </a:ext>
                    </a:extLst>
                  </p:cNvPr>
                  <p:cNvSpPr txBox="1"/>
                  <p:nvPr/>
                </p:nvSpPr>
                <p:spPr>
                  <a:xfrm>
                    <a:off x="4532603" y="8436424"/>
                    <a:ext cx="607859" cy="5539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_17870</a:t>
                    </a:r>
                  </a:p>
                  <a:p>
                    <a:pPr algn="ctr"/>
                    <a:r>
                      <a:rPr lang="fr-FR" sz="1000" b="1" i="1" dirty="0" err="1">
                        <a:latin typeface="Arial"/>
                        <a:cs typeface="Arial"/>
                      </a:rPr>
                      <a:t>hemE</a:t>
                    </a:r>
                    <a:endParaRPr lang="fr-FR" sz="1000" b="1" i="1" dirty="0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13" name="Groupe 1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C61BA4E-93B5-A443-AD0B-2F9A4A36D87C}"/>
                      </a:ext>
                    </a:extLst>
                  </p:cNvPr>
                  <p:cNvGrpSpPr/>
                  <p:nvPr/>
                </p:nvGrpSpPr>
                <p:grpSpPr>
                  <a:xfrm>
                    <a:off x="4544017" y="8159979"/>
                    <a:ext cx="601949" cy="307777"/>
                    <a:chOff x="4544017" y="8159979"/>
                    <a:chExt cx="601949" cy="307777"/>
                  </a:xfrm>
                </p:grpSpPr>
                <p:sp>
                  <p:nvSpPr>
                    <p:cNvPr id="530" name="ZoneTexte 52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0EBA908-9D97-E843-A248-93F4B50F204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44017" y="8159979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-</a:t>
                      </a:r>
                    </a:p>
                  </p:txBody>
                </p:sp>
                <p:sp>
                  <p:nvSpPr>
                    <p:cNvPr id="531" name="ZoneTexte 53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C0F38B0-A1BC-5A45-8D4D-C628CC656CB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90205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  <p:sp>
                  <p:nvSpPr>
                    <p:cNvPr id="532" name="ZoneTexte 53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B3E0B66-E5FA-694D-AD20-4A75AB1D919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56454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325" name="Parenthèse ouvrante 32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D58830-9D0A-7744-A62E-D8A5FE345D27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792840" y="8075297"/>
                    <a:ext cx="88428" cy="567484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22" name="Groupe 21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33DB5F3-FE66-AB48-8C04-14DFE4859AA3}"/>
                    </a:ext>
                  </a:extLst>
                </p:cNvPr>
                <p:cNvGrpSpPr/>
                <p:nvPr/>
              </p:nvGrpSpPr>
              <p:grpSpPr>
                <a:xfrm>
                  <a:off x="5123177" y="8159979"/>
                  <a:ext cx="654346" cy="830443"/>
                  <a:chOff x="5123177" y="8159979"/>
                  <a:chExt cx="654346" cy="830443"/>
                </a:xfrm>
              </p:grpSpPr>
              <p:sp>
                <p:nvSpPr>
                  <p:cNvPr id="508" name="ZoneTexte 50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766DB74-350B-C247-BBC4-AB9D8A09B4CB}"/>
                      </a:ext>
                    </a:extLst>
                  </p:cNvPr>
                  <p:cNvSpPr txBox="1"/>
                  <p:nvPr/>
                </p:nvSpPr>
                <p:spPr>
                  <a:xfrm>
                    <a:off x="5123177" y="8436424"/>
                    <a:ext cx="654346" cy="55399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_17875</a:t>
                    </a:r>
                  </a:p>
                  <a:p>
                    <a:pPr algn="ctr"/>
                    <a:r>
                      <a:rPr lang="fr-FR" sz="1000" b="1" i="1" dirty="0" err="1">
                        <a:latin typeface="Arial"/>
                        <a:cs typeface="Arial"/>
                      </a:rPr>
                      <a:t>hemN</a:t>
                    </a:r>
                    <a:r>
                      <a:rPr lang="fr-FR" sz="1000" b="1" i="1" dirty="0">
                        <a:latin typeface="Arial"/>
                        <a:cs typeface="Arial"/>
                      </a:rPr>
                      <a:t>/F</a:t>
                    </a:r>
                  </a:p>
                </p:txBody>
              </p:sp>
              <p:grpSp>
                <p:nvGrpSpPr>
                  <p:cNvPr id="14" name="Groupe 1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DC55E30-6596-BB4F-9521-CF9A11FE2D1F}"/>
                      </a:ext>
                    </a:extLst>
                  </p:cNvPr>
                  <p:cNvGrpSpPr/>
                  <p:nvPr/>
                </p:nvGrpSpPr>
                <p:grpSpPr>
                  <a:xfrm>
                    <a:off x="5155550" y="8159979"/>
                    <a:ext cx="601712" cy="307777"/>
                    <a:chOff x="5152616" y="8159979"/>
                    <a:chExt cx="601712" cy="307777"/>
                  </a:xfrm>
                </p:grpSpPr>
                <p:sp>
                  <p:nvSpPr>
                    <p:cNvPr id="533" name="ZoneTexte 53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B326E23-C4ED-6F48-B931-5609A9FED2E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52616" y="8159979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-</a:t>
                      </a:r>
                    </a:p>
                  </p:txBody>
                </p:sp>
                <p:sp>
                  <p:nvSpPr>
                    <p:cNvPr id="534" name="ZoneTexte 53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F9EF04A-0724-AD40-9163-DFD787ACA49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98804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  <p:sp>
                  <p:nvSpPr>
                    <p:cNvPr id="535" name="ZoneTexte 53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9D446DC-0129-B843-82A7-17809B05ACC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64816" y="8159979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/>
                          <a:cs typeface="Arial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326" name="Parenthèse ouvrante 3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30B3C80-29E4-934E-B114-0A957306B892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5400080" y="8075297"/>
                    <a:ext cx="88428" cy="567484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</p:grpSp>
        </p:grpSp>
        <p:sp>
          <p:nvSpPr>
            <p:cNvPr id="345" name="ZoneTexte 344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8A4E5C3-EB4E-1943-BB42-B7461DFC4744}"/>
                </a:ext>
              </a:extLst>
            </p:cNvPr>
            <p:cNvSpPr txBox="1"/>
            <p:nvPr/>
          </p:nvSpPr>
          <p:spPr>
            <a:xfrm>
              <a:off x="243774" y="8825620"/>
              <a:ext cx="63562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3 Fig. </a:t>
              </a: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ncrease of the </a:t>
              </a:r>
              <a:r>
                <a:rPr lang="en-GB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eme</a:t>
              </a: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biosynthesis gene expression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upon exposure to sublethal dose of H</a:t>
              </a:r>
              <a:r>
                <a:rPr lang="en-GB" sz="1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GB" sz="1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3753421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a="http://schemas.openxmlformats.org/drawingml/2006/main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</TotalTime>
  <Words>275</Words>
  <Application>Microsoft Macintosh PowerPoint</Application>
  <PresentationFormat>Présentation à l'écran (4:3)</PresentationFormat>
  <Paragraphs>203</Paragraphs>
  <Slides>1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nadia benaroudj</cp:lastModifiedBy>
  <cp:revision>29</cp:revision>
  <cp:lastPrinted>2020-03-17T19:36:43Z</cp:lastPrinted>
  <dcterms:created xsi:type="dcterms:W3CDTF">2020-04-03T11:58:54Z</dcterms:created>
  <dcterms:modified xsi:type="dcterms:W3CDTF">2020-04-03T12:02:56Z</dcterms:modified>
</cp:coreProperties>
</file>